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6"/>
  </p:notesMasterIdLst>
  <p:sldIdLst>
    <p:sldId id="260" r:id="rId2"/>
    <p:sldId id="261" r:id="rId3"/>
    <p:sldId id="262" r:id="rId4"/>
    <p:sldId id="258" r:id="rId5"/>
  </p:sldIdLst>
  <p:sldSz cx="6264275" cy="8423275"/>
  <p:notesSz cx="6858000" cy="9144000"/>
  <p:defaultTextStyle>
    <a:defPPr>
      <a:defRPr lang="ja-JP"/>
    </a:defPPr>
    <a:lvl1pPr marL="0" algn="l" defTabSz="839236" rtl="0" eaLnBrk="1" latinLnBrk="0" hangingPunct="1">
      <a:defRPr kumimoji="1" sz="1652" kern="1200">
        <a:solidFill>
          <a:schemeClr val="tx1"/>
        </a:solidFill>
        <a:latin typeface="+mn-lt"/>
        <a:ea typeface="+mn-ea"/>
        <a:cs typeface="+mn-cs"/>
      </a:defRPr>
    </a:lvl1pPr>
    <a:lvl2pPr marL="419618" algn="l" defTabSz="839236" rtl="0" eaLnBrk="1" latinLnBrk="0" hangingPunct="1">
      <a:defRPr kumimoji="1" sz="1652" kern="1200">
        <a:solidFill>
          <a:schemeClr val="tx1"/>
        </a:solidFill>
        <a:latin typeface="+mn-lt"/>
        <a:ea typeface="+mn-ea"/>
        <a:cs typeface="+mn-cs"/>
      </a:defRPr>
    </a:lvl2pPr>
    <a:lvl3pPr marL="839236" algn="l" defTabSz="839236" rtl="0" eaLnBrk="1" latinLnBrk="0" hangingPunct="1">
      <a:defRPr kumimoji="1" sz="1652" kern="1200">
        <a:solidFill>
          <a:schemeClr val="tx1"/>
        </a:solidFill>
        <a:latin typeface="+mn-lt"/>
        <a:ea typeface="+mn-ea"/>
        <a:cs typeface="+mn-cs"/>
      </a:defRPr>
    </a:lvl3pPr>
    <a:lvl4pPr marL="1258854" algn="l" defTabSz="839236" rtl="0" eaLnBrk="1" latinLnBrk="0" hangingPunct="1">
      <a:defRPr kumimoji="1" sz="1652" kern="1200">
        <a:solidFill>
          <a:schemeClr val="tx1"/>
        </a:solidFill>
        <a:latin typeface="+mn-lt"/>
        <a:ea typeface="+mn-ea"/>
        <a:cs typeface="+mn-cs"/>
      </a:defRPr>
    </a:lvl4pPr>
    <a:lvl5pPr marL="1678473" algn="l" defTabSz="839236" rtl="0" eaLnBrk="1" latinLnBrk="0" hangingPunct="1">
      <a:defRPr kumimoji="1" sz="1652" kern="1200">
        <a:solidFill>
          <a:schemeClr val="tx1"/>
        </a:solidFill>
        <a:latin typeface="+mn-lt"/>
        <a:ea typeface="+mn-ea"/>
        <a:cs typeface="+mn-cs"/>
      </a:defRPr>
    </a:lvl5pPr>
    <a:lvl6pPr marL="2098091" algn="l" defTabSz="839236" rtl="0" eaLnBrk="1" latinLnBrk="0" hangingPunct="1">
      <a:defRPr kumimoji="1" sz="1652" kern="1200">
        <a:solidFill>
          <a:schemeClr val="tx1"/>
        </a:solidFill>
        <a:latin typeface="+mn-lt"/>
        <a:ea typeface="+mn-ea"/>
        <a:cs typeface="+mn-cs"/>
      </a:defRPr>
    </a:lvl6pPr>
    <a:lvl7pPr marL="2517709" algn="l" defTabSz="839236" rtl="0" eaLnBrk="1" latinLnBrk="0" hangingPunct="1">
      <a:defRPr kumimoji="1" sz="1652" kern="1200">
        <a:solidFill>
          <a:schemeClr val="tx1"/>
        </a:solidFill>
        <a:latin typeface="+mn-lt"/>
        <a:ea typeface="+mn-ea"/>
        <a:cs typeface="+mn-cs"/>
      </a:defRPr>
    </a:lvl7pPr>
    <a:lvl8pPr marL="2937327" algn="l" defTabSz="839236" rtl="0" eaLnBrk="1" latinLnBrk="0" hangingPunct="1">
      <a:defRPr kumimoji="1" sz="1652" kern="1200">
        <a:solidFill>
          <a:schemeClr val="tx1"/>
        </a:solidFill>
        <a:latin typeface="+mn-lt"/>
        <a:ea typeface="+mn-ea"/>
        <a:cs typeface="+mn-cs"/>
      </a:defRPr>
    </a:lvl8pPr>
    <a:lvl9pPr marL="3356945" algn="l" defTabSz="839236" rtl="0" eaLnBrk="1" latinLnBrk="0" hangingPunct="1">
      <a:defRPr kumimoji="1" sz="165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>
          <p15:clr>
            <a:srgbClr val="A4A3A4"/>
          </p15:clr>
        </p15:guide>
        <p15:guide id="2" pos="19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140" d="100"/>
          <a:sy n="140" d="100"/>
        </p:scale>
        <p:origin x="-396" y="1410"/>
      </p:cViewPr>
      <p:guideLst>
        <p:guide orient="horz" pos="2653"/>
        <p:guide pos="19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7715D6-C8B9-474C-96D6-ADE17354B892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81238" y="1143000"/>
            <a:ext cx="2295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CD0A82-5630-417D-B41A-28766D9844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480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39236" rtl="0" eaLnBrk="1" latinLnBrk="0" hangingPunct="1">
      <a:defRPr kumimoji="1" sz="1101" kern="1200">
        <a:solidFill>
          <a:schemeClr val="tx1"/>
        </a:solidFill>
        <a:latin typeface="+mn-lt"/>
        <a:ea typeface="+mn-ea"/>
        <a:cs typeface="+mn-cs"/>
      </a:defRPr>
    </a:lvl1pPr>
    <a:lvl2pPr marL="419618" algn="l" defTabSz="839236" rtl="0" eaLnBrk="1" latinLnBrk="0" hangingPunct="1">
      <a:defRPr kumimoji="1" sz="1101" kern="1200">
        <a:solidFill>
          <a:schemeClr val="tx1"/>
        </a:solidFill>
        <a:latin typeface="+mn-lt"/>
        <a:ea typeface="+mn-ea"/>
        <a:cs typeface="+mn-cs"/>
      </a:defRPr>
    </a:lvl2pPr>
    <a:lvl3pPr marL="839236" algn="l" defTabSz="839236" rtl="0" eaLnBrk="1" latinLnBrk="0" hangingPunct="1">
      <a:defRPr kumimoji="1" sz="1101" kern="1200">
        <a:solidFill>
          <a:schemeClr val="tx1"/>
        </a:solidFill>
        <a:latin typeface="+mn-lt"/>
        <a:ea typeface="+mn-ea"/>
        <a:cs typeface="+mn-cs"/>
      </a:defRPr>
    </a:lvl3pPr>
    <a:lvl4pPr marL="1258854" algn="l" defTabSz="839236" rtl="0" eaLnBrk="1" latinLnBrk="0" hangingPunct="1">
      <a:defRPr kumimoji="1" sz="1101" kern="1200">
        <a:solidFill>
          <a:schemeClr val="tx1"/>
        </a:solidFill>
        <a:latin typeface="+mn-lt"/>
        <a:ea typeface="+mn-ea"/>
        <a:cs typeface="+mn-cs"/>
      </a:defRPr>
    </a:lvl4pPr>
    <a:lvl5pPr marL="1678473" algn="l" defTabSz="839236" rtl="0" eaLnBrk="1" latinLnBrk="0" hangingPunct="1">
      <a:defRPr kumimoji="1" sz="1101" kern="1200">
        <a:solidFill>
          <a:schemeClr val="tx1"/>
        </a:solidFill>
        <a:latin typeface="+mn-lt"/>
        <a:ea typeface="+mn-ea"/>
        <a:cs typeface="+mn-cs"/>
      </a:defRPr>
    </a:lvl5pPr>
    <a:lvl6pPr marL="2098091" algn="l" defTabSz="839236" rtl="0" eaLnBrk="1" latinLnBrk="0" hangingPunct="1">
      <a:defRPr kumimoji="1" sz="1101" kern="1200">
        <a:solidFill>
          <a:schemeClr val="tx1"/>
        </a:solidFill>
        <a:latin typeface="+mn-lt"/>
        <a:ea typeface="+mn-ea"/>
        <a:cs typeface="+mn-cs"/>
      </a:defRPr>
    </a:lvl6pPr>
    <a:lvl7pPr marL="2517709" algn="l" defTabSz="839236" rtl="0" eaLnBrk="1" latinLnBrk="0" hangingPunct="1">
      <a:defRPr kumimoji="1" sz="1101" kern="1200">
        <a:solidFill>
          <a:schemeClr val="tx1"/>
        </a:solidFill>
        <a:latin typeface="+mn-lt"/>
        <a:ea typeface="+mn-ea"/>
        <a:cs typeface="+mn-cs"/>
      </a:defRPr>
    </a:lvl7pPr>
    <a:lvl8pPr marL="2937327" algn="l" defTabSz="839236" rtl="0" eaLnBrk="1" latinLnBrk="0" hangingPunct="1">
      <a:defRPr kumimoji="1" sz="1101" kern="1200">
        <a:solidFill>
          <a:schemeClr val="tx1"/>
        </a:solidFill>
        <a:latin typeface="+mn-lt"/>
        <a:ea typeface="+mn-ea"/>
        <a:cs typeface="+mn-cs"/>
      </a:defRPr>
    </a:lvl8pPr>
    <a:lvl9pPr marL="3356945" algn="l" defTabSz="839236" rtl="0" eaLnBrk="1" latinLnBrk="0" hangingPunct="1">
      <a:defRPr kumimoji="1" sz="110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52815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963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2823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5268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6407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5615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712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7954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0848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8976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494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A58A80-157D-4E58-9ABA-2A4F34AA25C3}" type="datetimeFigureOut">
              <a:rPr kumimoji="1" lang="ja-JP" altLang="en-US" smtClean="0"/>
              <a:t>201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829C4E-A2A9-45AD-9CE5-B401220C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9734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kumimoji="1"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kumimoji="1"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2"/>
          <p:cNvGrpSpPr>
            <a:grpSpLocks noChangeAspect="1"/>
          </p:cNvGrpSpPr>
          <p:nvPr/>
        </p:nvGrpSpPr>
        <p:grpSpPr bwMode="auto">
          <a:xfrm>
            <a:off x="3152462" y="1437071"/>
            <a:ext cx="2442001" cy="3175515"/>
            <a:chOff x="5092876" y="1727002"/>
            <a:chExt cx="3043108" cy="3956588"/>
          </a:xfrm>
        </p:grpSpPr>
        <p:pic>
          <p:nvPicPr>
            <p:cNvPr id="18" name="図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12993" y="2184941"/>
              <a:ext cx="2915564" cy="2915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9" name="グループ化 7"/>
            <p:cNvGrpSpPr>
              <a:grpSpLocks/>
            </p:cNvGrpSpPr>
            <p:nvPr/>
          </p:nvGrpSpPr>
          <p:grpSpPr bwMode="auto">
            <a:xfrm>
              <a:off x="5092876" y="1727002"/>
              <a:ext cx="3043108" cy="3956588"/>
              <a:chOff x="5560114" y="1726978"/>
              <a:chExt cx="3043111" cy="3957041"/>
            </a:xfrm>
          </p:grpSpPr>
          <p:grpSp>
            <p:nvGrpSpPr>
              <p:cNvPr id="20" name="グループ化 6"/>
              <p:cNvGrpSpPr>
                <a:grpSpLocks/>
              </p:cNvGrpSpPr>
              <p:nvPr/>
            </p:nvGrpSpPr>
            <p:grpSpPr bwMode="auto">
              <a:xfrm>
                <a:off x="5560114" y="1726978"/>
                <a:ext cx="3043111" cy="3957041"/>
                <a:chOff x="5588689" y="1726978"/>
                <a:chExt cx="3043111" cy="3957041"/>
              </a:xfrm>
            </p:grpSpPr>
            <p:grpSp>
              <p:nvGrpSpPr>
                <p:cNvPr id="22" name="グループ化 14"/>
                <p:cNvGrpSpPr>
                  <a:grpSpLocks/>
                </p:cNvGrpSpPr>
                <p:nvPr/>
              </p:nvGrpSpPr>
              <p:grpSpPr bwMode="auto">
                <a:xfrm>
                  <a:off x="5908683" y="2724354"/>
                  <a:ext cx="2508061" cy="2241868"/>
                  <a:chOff x="6181536" y="2851429"/>
                  <a:chExt cx="2978321" cy="2662219"/>
                </a:xfrm>
              </p:grpSpPr>
              <p:sp>
                <p:nvSpPr>
                  <p:cNvPr id="25" name="正方形/長方形 24"/>
                  <p:cNvSpPr/>
                  <p:nvPr/>
                </p:nvSpPr>
                <p:spPr>
                  <a:xfrm>
                    <a:off x="8303040" y="4762403"/>
                    <a:ext cx="107445" cy="10744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ja-JP" altLang="en-US"/>
                  </a:p>
                </p:txBody>
              </p:sp>
              <p:sp>
                <p:nvSpPr>
                  <p:cNvPr id="26" name="二等辺三角形 25"/>
                  <p:cNvSpPr/>
                  <p:nvPr/>
                </p:nvSpPr>
                <p:spPr>
                  <a:xfrm>
                    <a:off x="7795974" y="5133736"/>
                    <a:ext cx="107446" cy="107441"/>
                  </a:xfrm>
                  <a:prstGeom prst="triangle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ja-JP" altLang="en-US"/>
                  </a:p>
                </p:txBody>
              </p:sp>
              <p:cxnSp>
                <p:nvCxnSpPr>
                  <p:cNvPr id="27" name="直線コネクタ 26"/>
                  <p:cNvCxnSpPr/>
                  <p:nvPr/>
                </p:nvCxnSpPr>
                <p:spPr>
                  <a:xfrm flipV="1">
                    <a:off x="8016520" y="3416558"/>
                    <a:ext cx="514605" cy="16399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8" name="テキスト ボックス 3892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425246" y="3126998"/>
                    <a:ext cx="734611" cy="4333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6350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kumimoji="1"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algn="just"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ja-JP" sz="16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A</a:t>
                    </a:r>
                    <a:r>
                      <a:rPr lang="en-US" altLang="ja-JP" sz="1600" baseline="300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1</a:t>
                    </a:r>
                    <a:r>
                      <a:rPr lang="en-US" altLang="ja-JP" sz="16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a </a:t>
                    </a:r>
                    <a:endParaRPr lang="ja-JP" altLang="ja-JP" sz="1600" dirty="0"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29" name="直線コネクタ 28"/>
                  <p:cNvCxnSpPr/>
                  <p:nvPr/>
                </p:nvCxnSpPr>
                <p:spPr>
                  <a:xfrm flipH="1" flipV="1">
                    <a:off x="6580432" y="3203359"/>
                    <a:ext cx="885385" cy="827487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0" name="テキスト ボックス 3892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181536" y="2851429"/>
                    <a:ext cx="799096" cy="4318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6350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kumimoji="1"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algn="just"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ja-JP" sz="16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A</a:t>
                    </a:r>
                    <a:r>
                      <a:rPr lang="en-US" altLang="ja-JP" sz="1600" baseline="300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1</a:t>
                    </a:r>
                    <a:r>
                      <a:rPr lang="en-US" altLang="ja-JP" sz="16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b </a:t>
                    </a:r>
                    <a:endParaRPr lang="ja-JP" altLang="ja-JP" sz="1600" dirty="0"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1" name="テキスト ボックス 3892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224890" y="5081848"/>
                    <a:ext cx="1239837" cy="4318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6350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kumimoji="1"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algn="just"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ja-JP" sz="16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A</a:t>
                    </a:r>
                    <a:r>
                      <a:rPr lang="en-US" altLang="ja-JP" sz="1600" baseline="300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3</a:t>
                    </a:r>
                    <a:r>
                      <a:rPr lang="en-US" altLang="ja-JP" sz="16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+A</a:t>
                    </a:r>
                    <a:r>
                      <a:rPr lang="en-US" altLang="ja-JP" sz="1600" baseline="300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1</a:t>
                    </a:r>
                    <a:r>
                      <a:rPr lang="en-US" altLang="ja-JP" sz="16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b</a:t>
                    </a:r>
                    <a:endParaRPr lang="ja-JP" altLang="ja-JP" sz="1600" dirty="0"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32" name="直線コネクタ 31"/>
                  <p:cNvCxnSpPr/>
                  <p:nvPr/>
                </p:nvCxnSpPr>
                <p:spPr>
                  <a:xfrm flipH="1">
                    <a:off x="7293496" y="4706024"/>
                    <a:ext cx="544763" cy="57302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3" name="テキスト ボックス 3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276436" y="3834838"/>
                    <a:ext cx="366713" cy="46196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kumimoji="1"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ja-JP" altLang="en-US" sz="2400" dirty="0">
                        <a:solidFill>
                          <a:schemeClr val="bg1"/>
                        </a:solidFill>
                      </a:rPr>
                      <a:t>*</a:t>
                    </a:r>
                  </a:p>
                </p:txBody>
              </p:sp>
              <p:sp>
                <p:nvSpPr>
                  <p:cNvPr id="34" name="テキスト ボックス 3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664415" y="4402138"/>
                    <a:ext cx="366712" cy="46196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kumimoji="1"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ja-JP" altLang="en-US" sz="2400">
                        <a:solidFill>
                          <a:schemeClr val="bg1"/>
                        </a:solidFill>
                      </a:rPr>
                      <a:t>*</a:t>
                    </a:r>
                  </a:p>
                </p:txBody>
              </p:sp>
              <p:sp>
                <p:nvSpPr>
                  <p:cNvPr id="35" name="テキスト ボックス 3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723650" y="3326651"/>
                    <a:ext cx="365125" cy="4603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kumimoji="1"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ja-JP" altLang="en-US" sz="2400" dirty="0">
                        <a:solidFill>
                          <a:schemeClr val="bg1"/>
                        </a:solidFill>
                      </a:rPr>
                      <a:t>*</a:t>
                    </a:r>
                  </a:p>
                </p:txBody>
              </p:sp>
            </p:grpSp>
            <p:sp>
              <p:nvSpPr>
                <p:cNvPr id="23" name="テキスト ボックス 35"/>
                <p:cNvSpPr txBox="1">
                  <a:spLocks noChangeArrowheads="1"/>
                </p:cNvSpPr>
                <p:nvPr/>
              </p:nvSpPr>
              <p:spPr bwMode="auto">
                <a:xfrm>
                  <a:off x="5626075" y="5108734"/>
                  <a:ext cx="3005725" cy="575285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algn="ctr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r>
                    <a:rPr lang="en-US" altLang="ja-JP" sz="1200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r>
                    <a:rPr lang="en-US" altLang="ja-JP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 from Tr. sup, A</a:t>
                  </a:r>
                  <a:r>
                    <a:rPr lang="en-US" altLang="ja-JP" sz="1200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r>
                    <a:rPr lang="en-US" altLang="ja-JP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 from A</a:t>
                  </a:r>
                  <a:r>
                    <a:rPr lang="en-US" altLang="ja-JP" sz="1200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r>
                    <a:rPr lang="en-US" altLang="ja-JP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: </a:t>
                  </a:r>
                  <a:r>
                    <a:rPr lang="en-US" altLang="ja-JP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3.3%</a:t>
                  </a:r>
                  <a:endParaRPr lang="ja-JP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コンテンツ プレースホルダー 7"/>
                <p:cNvSpPr txBox="1">
                  <a:spLocks/>
                </p:cNvSpPr>
                <p:nvPr/>
              </p:nvSpPr>
              <p:spPr bwMode="auto">
                <a:xfrm>
                  <a:off x="5588689" y="1726978"/>
                  <a:ext cx="496847" cy="415877"/>
                </a:xfrm>
                <a:prstGeom prst="rect">
                  <a:avLst/>
                </a:prstGeom>
              </p:spPr>
              <p:txBody>
                <a:bodyPr>
                  <a:noAutofit/>
                </a:bodyPr>
                <a:lstStyle>
                  <a:lvl1pPr marL="228600" indent="-228600" algn="l" defTabSz="914400" rtl="0" eaLnBrk="1" latinLnBrk="0" hangingPunct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685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5146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971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429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886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indent="0" algn="ctr" fontAlgn="auto">
                    <a:spcAft>
                      <a:spcPts val="0"/>
                    </a:spcAft>
                    <a:buFont typeface="Arial" panose="020B0604020202020204" pitchFamily="34" charset="0"/>
                    <a:buNone/>
                    <a:defRPr/>
                  </a:pPr>
                  <a:r>
                    <a:rPr lang="en-US" altLang="ja-JP" sz="2600" dirty="0" smtClean="0"/>
                    <a:t>b</a:t>
                  </a:r>
                  <a:endParaRPr lang="ja-JP" altLang="en-US" sz="2600" dirty="0"/>
                </a:p>
              </p:txBody>
            </p:sp>
          </p:grpSp>
          <p:sp>
            <p:nvSpPr>
              <p:cNvPr id="21" name="テキスト ボックス 35"/>
              <p:cNvSpPr txBox="1">
                <a:spLocks noChangeArrowheads="1"/>
              </p:cNvSpPr>
              <p:nvPr/>
            </p:nvSpPr>
            <p:spPr bwMode="auto">
              <a:xfrm>
                <a:off x="6186877" y="1895163"/>
                <a:ext cx="2153353" cy="345171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. sup + A. </a:t>
                </a:r>
                <a:r>
                  <a:rPr lang="en-US" altLang="ja-JP" sz="1200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c</a:t>
                </a: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ype</a:t>
                </a:r>
                <a:endParaRPr lang="ja-JP" altLang="en-US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4" name="グループ化 7"/>
          <p:cNvGrpSpPr>
            <a:grpSpLocks/>
          </p:cNvGrpSpPr>
          <p:nvPr/>
        </p:nvGrpSpPr>
        <p:grpSpPr bwMode="auto">
          <a:xfrm>
            <a:off x="748986" y="1801008"/>
            <a:ext cx="2340000" cy="2340000"/>
            <a:chOff x="2192723" y="2210613"/>
            <a:chExt cx="2919689" cy="2919687"/>
          </a:xfrm>
        </p:grpSpPr>
        <p:pic>
          <p:nvPicPr>
            <p:cNvPr id="5" name="図 6"/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2723" y="2210613"/>
              <a:ext cx="2919689" cy="29196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6" name="グループ化 5"/>
            <p:cNvGrpSpPr>
              <a:grpSpLocks/>
            </p:cNvGrpSpPr>
            <p:nvPr/>
          </p:nvGrpSpPr>
          <p:grpSpPr bwMode="auto">
            <a:xfrm>
              <a:off x="2421883" y="2480508"/>
              <a:ext cx="1975007" cy="2249709"/>
              <a:chOff x="2481018" y="2529702"/>
              <a:chExt cx="2344477" cy="2670569"/>
            </a:xfrm>
          </p:grpSpPr>
          <p:cxnSp>
            <p:nvCxnSpPr>
              <p:cNvPr id="7" name="直線コネクタ 6"/>
              <p:cNvCxnSpPr/>
              <p:nvPr/>
            </p:nvCxnSpPr>
            <p:spPr bwMode="auto">
              <a:xfrm flipH="1" flipV="1">
                <a:off x="3193588" y="2886719"/>
                <a:ext cx="1072370" cy="461741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2481018" y="2529702"/>
                <a:ext cx="746498" cy="4174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1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正方形/長方形 8"/>
              <p:cNvSpPr/>
              <p:nvPr/>
            </p:nvSpPr>
            <p:spPr bwMode="auto">
              <a:xfrm>
                <a:off x="4660340" y="4226876"/>
                <a:ext cx="107425" cy="10365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10" name="二等辺三角形 9"/>
              <p:cNvSpPr/>
              <p:nvPr/>
            </p:nvSpPr>
            <p:spPr bwMode="auto">
              <a:xfrm>
                <a:off x="3954183" y="5094730"/>
                <a:ext cx="107425" cy="105541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11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4096328" y="3122779"/>
                <a:ext cx="364988" cy="4466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40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12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4460507" y="3270916"/>
                <a:ext cx="364988" cy="4466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40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13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2548074" y="3236315"/>
                <a:ext cx="746498" cy="4174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1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b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" name="直線コネクタ 13"/>
              <p:cNvCxnSpPr/>
              <p:nvPr/>
            </p:nvCxnSpPr>
            <p:spPr bwMode="auto">
              <a:xfrm flipH="1">
                <a:off x="3198435" y="3523930"/>
                <a:ext cx="1404069" cy="28271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15" name="テキスト ボックス 33"/>
          <p:cNvSpPr txBox="1">
            <a:spLocks noChangeArrowheads="1"/>
          </p:cNvSpPr>
          <p:nvPr/>
        </p:nvSpPr>
        <p:spPr bwMode="auto">
          <a:xfrm>
            <a:off x="710410" y="4150921"/>
            <a:ext cx="2376000" cy="46166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+ A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from Tr. sup: 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5.6%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33"/>
          <p:cNvSpPr txBox="1">
            <a:spLocks noChangeArrowheads="1"/>
          </p:cNvSpPr>
          <p:nvPr/>
        </p:nvSpPr>
        <p:spPr bwMode="auto">
          <a:xfrm>
            <a:off x="1175563" y="1563053"/>
            <a:ext cx="1728002" cy="276999"/>
          </a:xfrm>
          <a:prstGeom prst="rect">
            <a:avLst/>
          </a:prstGeom>
          <a:noFill/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. sup + A. </a:t>
            </a:r>
            <a:r>
              <a:rPr lang="en-US" altLang="ja-JP" sz="120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c</a:t>
            </a:r>
            <a:r>
              <a:rPr lang="en-US" altLang="ja-JP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e</a:t>
            </a:r>
            <a:endParaRPr lang="ja-JP" altLang="en-US" sz="12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コンテンツ プレースホルダー 7"/>
          <p:cNvSpPr txBox="1">
            <a:spLocks/>
          </p:cNvSpPr>
          <p:nvPr/>
        </p:nvSpPr>
        <p:spPr bwMode="auto">
          <a:xfrm>
            <a:off x="698126" y="1427541"/>
            <a:ext cx="398271" cy="333377"/>
          </a:xfrm>
          <a:prstGeom prst="rect">
            <a:avLst/>
          </a:prstGeom>
        </p:spPr>
        <p:txBody>
          <a:bodyPr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 fontAlgn="auto"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2600" dirty="0"/>
              <a:t>a</a:t>
            </a:r>
            <a:endParaRPr lang="ja-JP" altLang="en-US" sz="2600" dirty="0"/>
          </a:p>
        </p:txBody>
      </p:sp>
      <p:sp>
        <p:nvSpPr>
          <p:cNvPr id="37" name="タイトル 1"/>
          <p:cNvSpPr>
            <a:spLocks noGrp="1"/>
          </p:cNvSpPr>
          <p:nvPr>
            <p:ph type="title"/>
          </p:nvPr>
        </p:nvSpPr>
        <p:spPr>
          <a:xfrm>
            <a:off x="288236" y="223701"/>
            <a:ext cx="2749550" cy="682625"/>
          </a:xfrm>
        </p:spPr>
        <p:txBody>
          <a:bodyPr/>
          <a:lstStyle/>
          <a:p>
            <a:pPr eaLnBrk="1" hangingPunct="1"/>
            <a:r>
              <a:rPr lang="en-US" altLang="ja-JP" sz="20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-Figure 1</a:t>
            </a:r>
            <a:endParaRPr lang="ja-JP" altLang="en-US" sz="2000" u="sng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62112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0" name="グループ化 12323"/>
          <p:cNvGrpSpPr>
            <a:grpSpLocks noChangeAspect="1"/>
          </p:cNvGrpSpPr>
          <p:nvPr/>
        </p:nvGrpSpPr>
        <p:grpSpPr bwMode="auto">
          <a:xfrm>
            <a:off x="3719063" y="2883237"/>
            <a:ext cx="2462863" cy="2700684"/>
            <a:chOff x="2414317" y="3530972"/>
            <a:chExt cx="2983175" cy="3271249"/>
          </a:xfrm>
        </p:grpSpPr>
        <p:grpSp>
          <p:nvGrpSpPr>
            <p:cNvPr id="211" name="グループ化 14335"/>
            <p:cNvGrpSpPr>
              <a:grpSpLocks/>
            </p:cNvGrpSpPr>
            <p:nvPr/>
          </p:nvGrpSpPr>
          <p:grpSpPr bwMode="auto">
            <a:xfrm>
              <a:off x="2563134" y="3960412"/>
              <a:ext cx="2834358" cy="2841809"/>
              <a:chOff x="2562357" y="3959978"/>
              <a:chExt cx="2835134" cy="2841773"/>
            </a:xfrm>
          </p:grpSpPr>
          <p:pic>
            <p:nvPicPr>
              <p:cNvPr id="214" name="図 30"/>
              <p:cNvPicPr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77" t="6104" r="8300" b="14177"/>
              <a:stretch/>
            </p:blipFill>
            <p:spPr bwMode="auto">
              <a:xfrm>
                <a:off x="2589996" y="3959978"/>
                <a:ext cx="2617045" cy="22674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215" name="グループ化 30"/>
              <p:cNvGrpSpPr>
                <a:grpSpLocks/>
              </p:cNvGrpSpPr>
              <p:nvPr/>
            </p:nvGrpSpPr>
            <p:grpSpPr bwMode="auto">
              <a:xfrm>
                <a:off x="2562357" y="4520596"/>
                <a:ext cx="2835134" cy="2281155"/>
                <a:chOff x="2562140" y="4540981"/>
                <a:chExt cx="2861015" cy="2382384"/>
              </a:xfrm>
            </p:grpSpPr>
            <p:sp>
              <p:nvSpPr>
                <p:cNvPr id="216" name="正方形/長方形 215"/>
                <p:cNvSpPr/>
                <p:nvPr/>
              </p:nvSpPr>
              <p:spPr bwMode="auto">
                <a:xfrm>
                  <a:off x="3998599" y="5693421"/>
                  <a:ext cx="108965" cy="10776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ja-JP" altLang="en-US"/>
                </a:p>
              </p:txBody>
            </p:sp>
            <p:sp>
              <p:nvSpPr>
                <p:cNvPr id="217" name="テキスト ボックス 33"/>
                <p:cNvSpPr txBox="1">
                  <a:spLocks noChangeArrowheads="1"/>
                </p:cNvSpPr>
                <p:nvPr/>
              </p:nvSpPr>
              <p:spPr bwMode="auto">
                <a:xfrm>
                  <a:off x="3492474" y="4911725"/>
                  <a:ext cx="460375" cy="4000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ja-JP" altLang="en-US" sz="2000">
                      <a:solidFill>
                        <a:schemeClr val="bg1"/>
                      </a:solidFill>
                    </a:rPr>
                    <a:t>*</a:t>
                  </a:r>
                </a:p>
              </p:txBody>
            </p:sp>
            <p:sp>
              <p:nvSpPr>
                <p:cNvPr id="218" name="テキスト ボックス 33"/>
                <p:cNvSpPr txBox="1">
                  <a:spLocks noChangeArrowheads="1"/>
                </p:cNvSpPr>
                <p:nvPr/>
              </p:nvSpPr>
              <p:spPr bwMode="auto">
                <a:xfrm>
                  <a:off x="3133002" y="5197817"/>
                  <a:ext cx="458788" cy="4000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ja-JP" altLang="en-US" sz="2000" dirty="0">
                      <a:solidFill>
                        <a:schemeClr val="bg1"/>
                      </a:solidFill>
                    </a:rPr>
                    <a:t>*</a:t>
                  </a:r>
                </a:p>
              </p:txBody>
            </p:sp>
            <p:sp>
              <p:nvSpPr>
                <p:cNvPr id="219" name="テキスト ボックス 33"/>
                <p:cNvSpPr txBox="1">
                  <a:spLocks noChangeArrowheads="1"/>
                </p:cNvSpPr>
                <p:nvPr/>
              </p:nvSpPr>
              <p:spPr bwMode="auto">
                <a:xfrm>
                  <a:off x="4343919" y="5220124"/>
                  <a:ext cx="295275" cy="4000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ja-JP" altLang="en-US" sz="2000" dirty="0">
                      <a:solidFill>
                        <a:schemeClr val="bg1"/>
                      </a:solidFill>
                    </a:rPr>
                    <a:t>*</a:t>
                  </a:r>
                </a:p>
              </p:txBody>
            </p:sp>
            <p:sp>
              <p:nvSpPr>
                <p:cNvPr id="220" name="テキスト ボックス 38927"/>
                <p:cNvSpPr txBox="1">
                  <a:spLocks noChangeArrowheads="1"/>
                </p:cNvSpPr>
                <p:nvPr/>
              </p:nvSpPr>
              <p:spPr bwMode="auto">
                <a:xfrm>
                  <a:off x="2562140" y="4837920"/>
                  <a:ext cx="711200" cy="4317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6350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algn="just"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A</a:t>
                  </a:r>
                  <a:r>
                    <a:rPr lang="en-US" altLang="ja-JP" sz="1600" baseline="30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2</a:t>
                  </a:r>
                  <a:r>
                    <a:rPr lang="en-US" altLang="ja-JP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b </a:t>
                  </a:r>
                  <a:endParaRPr lang="ja-JP" altLang="ja-JP" sz="1600" dirty="0"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1" name="テキスト ボックス 38927"/>
                <p:cNvSpPr txBox="1">
                  <a:spLocks noChangeArrowheads="1"/>
                </p:cNvSpPr>
                <p:nvPr/>
              </p:nvSpPr>
              <p:spPr bwMode="auto">
                <a:xfrm>
                  <a:off x="2801251" y="5712618"/>
                  <a:ext cx="711200" cy="4317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6350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algn="just"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A</a:t>
                  </a:r>
                  <a:r>
                    <a:rPr lang="en-US" altLang="ja-JP" sz="1600" baseline="30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2</a:t>
                  </a:r>
                  <a:r>
                    <a:rPr lang="en-US" altLang="ja-JP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a </a:t>
                  </a:r>
                  <a:endParaRPr lang="ja-JP" altLang="ja-JP" sz="1600" dirty="0"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2" name="テキスト ボックス 38927"/>
                <p:cNvSpPr txBox="1">
                  <a:spLocks noChangeArrowheads="1"/>
                </p:cNvSpPr>
                <p:nvPr/>
              </p:nvSpPr>
              <p:spPr bwMode="auto">
                <a:xfrm>
                  <a:off x="4638915" y="4540981"/>
                  <a:ext cx="520220" cy="4318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6350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algn="just"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A</a:t>
                  </a:r>
                  <a:r>
                    <a:rPr lang="en-US" altLang="ja-JP" sz="1600" baseline="30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3</a:t>
                  </a:r>
                  <a:r>
                    <a:rPr lang="en-US" altLang="ja-JP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 </a:t>
                  </a:r>
                  <a:endParaRPr lang="ja-JP" altLang="ja-JP" sz="1600" dirty="0"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23" name="直線コネクタ 5149"/>
                <p:cNvCxnSpPr/>
                <p:nvPr/>
              </p:nvCxnSpPr>
              <p:spPr bwMode="auto">
                <a:xfrm>
                  <a:off x="3044713" y="5063262"/>
                  <a:ext cx="535210" cy="315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4" name="直線コネクタ 223"/>
                <p:cNvCxnSpPr/>
                <p:nvPr/>
              </p:nvCxnSpPr>
              <p:spPr bwMode="auto">
                <a:xfrm flipV="1">
                  <a:off x="3120909" y="5457394"/>
                  <a:ext cx="179472" cy="31500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5" name="直線コネクタ 224"/>
                <p:cNvCxnSpPr/>
                <p:nvPr/>
              </p:nvCxnSpPr>
              <p:spPr bwMode="auto">
                <a:xfrm flipV="1">
                  <a:off x="4553038" y="4884351"/>
                  <a:ext cx="246774" cy="46919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6" name="フリーフォーム 225"/>
                <p:cNvSpPr/>
                <p:nvPr/>
              </p:nvSpPr>
              <p:spPr>
                <a:xfrm>
                  <a:off x="4846282" y="6308513"/>
                  <a:ext cx="576873" cy="459247"/>
                </a:xfrm>
                <a:custGeom>
                  <a:avLst/>
                  <a:gdLst>
                    <a:gd name="connsiteX0" fmla="*/ 63305 w 576835"/>
                    <a:gd name="connsiteY0" fmla="*/ 0 h 460186"/>
                    <a:gd name="connsiteX1" fmla="*/ 63305 w 576835"/>
                    <a:gd name="connsiteY1" fmla="*/ 0 h 460186"/>
                    <a:gd name="connsiteX2" fmla="*/ 288388 w 576835"/>
                    <a:gd name="connsiteY2" fmla="*/ 14068 h 460186"/>
                    <a:gd name="connsiteX3" fmla="*/ 316523 w 576835"/>
                    <a:gd name="connsiteY3" fmla="*/ 21102 h 460186"/>
                    <a:gd name="connsiteX4" fmla="*/ 358726 w 576835"/>
                    <a:gd name="connsiteY4" fmla="*/ 35169 h 460186"/>
                    <a:gd name="connsiteX5" fmla="*/ 443132 w 576835"/>
                    <a:gd name="connsiteY5" fmla="*/ 42203 h 460186"/>
                    <a:gd name="connsiteX6" fmla="*/ 464234 w 576835"/>
                    <a:gd name="connsiteY6" fmla="*/ 56271 h 460186"/>
                    <a:gd name="connsiteX7" fmla="*/ 520505 w 576835"/>
                    <a:gd name="connsiteY7" fmla="*/ 70338 h 460186"/>
                    <a:gd name="connsiteX8" fmla="*/ 541606 w 576835"/>
                    <a:gd name="connsiteY8" fmla="*/ 84406 h 460186"/>
                    <a:gd name="connsiteX9" fmla="*/ 555674 w 576835"/>
                    <a:gd name="connsiteY9" fmla="*/ 126609 h 460186"/>
                    <a:gd name="connsiteX10" fmla="*/ 548640 w 576835"/>
                    <a:gd name="connsiteY10" fmla="*/ 436098 h 460186"/>
                    <a:gd name="connsiteX11" fmla="*/ 337625 w 576835"/>
                    <a:gd name="connsiteY11" fmla="*/ 429065 h 460186"/>
                    <a:gd name="connsiteX12" fmla="*/ 77372 w 576835"/>
                    <a:gd name="connsiteY12" fmla="*/ 422031 h 460186"/>
                    <a:gd name="connsiteX13" fmla="*/ 0 w 576835"/>
                    <a:gd name="connsiteY13" fmla="*/ 386862 h 460186"/>
                    <a:gd name="connsiteX14" fmla="*/ 7034 w 576835"/>
                    <a:gd name="connsiteY14" fmla="*/ 98474 h 460186"/>
                    <a:gd name="connsiteX15" fmla="*/ 21102 w 576835"/>
                    <a:gd name="connsiteY15" fmla="*/ 70338 h 460186"/>
                    <a:gd name="connsiteX16" fmla="*/ 28135 w 576835"/>
                    <a:gd name="connsiteY16" fmla="*/ 49237 h 460186"/>
                    <a:gd name="connsiteX17" fmla="*/ 63305 w 576835"/>
                    <a:gd name="connsiteY17" fmla="*/ 0 h 46018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</a:cxnLst>
                  <a:rect l="l" t="t" r="r" b="b"/>
                  <a:pathLst>
                    <a:path w="576835" h="460186">
                      <a:moveTo>
                        <a:pt x="63305" y="0"/>
                      </a:moveTo>
                      <a:lnTo>
                        <a:pt x="63305" y="0"/>
                      </a:lnTo>
                      <a:cubicBezTo>
                        <a:pt x="138333" y="4689"/>
                        <a:pt x="213474" y="7825"/>
                        <a:pt x="288388" y="14068"/>
                      </a:cubicBezTo>
                      <a:cubicBezTo>
                        <a:pt x="298022" y="14871"/>
                        <a:pt x="307264" y="18324"/>
                        <a:pt x="316523" y="21102"/>
                      </a:cubicBezTo>
                      <a:cubicBezTo>
                        <a:pt x="330726" y="25363"/>
                        <a:pt x="343949" y="33938"/>
                        <a:pt x="358726" y="35169"/>
                      </a:cubicBezTo>
                      <a:lnTo>
                        <a:pt x="443132" y="42203"/>
                      </a:lnTo>
                      <a:cubicBezTo>
                        <a:pt x="450166" y="46892"/>
                        <a:pt x="456673" y="52490"/>
                        <a:pt x="464234" y="56271"/>
                      </a:cubicBezTo>
                      <a:cubicBezTo>
                        <a:pt x="478656" y="63482"/>
                        <a:pt x="507124" y="67662"/>
                        <a:pt x="520505" y="70338"/>
                      </a:cubicBezTo>
                      <a:cubicBezTo>
                        <a:pt x="527539" y="75027"/>
                        <a:pt x="537126" y="77237"/>
                        <a:pt x="541606" y="84406"/>
                      </a:cubicBezTo>
                      <a:cubicBezTo>
                        <a:pt x="549465" y="96981"/>
                        <a:pt x="555674" y="126609"/>
                        <a:pt x="555674" y="126609"/>
                      </a:cubicBezTo>
                      <a:cubicBezTo>
                        <a:pt x="553329" y="229772"/>
                        <a:pt x="608985" y="352393"/>
                        <a:pt x="548640" y="436098"/>
                      </a:cubicBezTo>
                      <a:cubicBezTo>
                        <a:pt x="507483" y="493187"/>
                        <a:pt x="407971" y="431165"/>
                        <a:pt x="337625" y="429065"/>
                      </a:cubicBezTo>
                      <a:lnTo>
                        <a:pt x="77372" y="422031"/>
                      </a:lnTo>
                      <a:cubicBezTo>
                        <a:pt x="25222" y="387263"/>
                        <a:pt x="51748" y="397210"/>
                        <a:pt x="0" y="386862"/>
                      </a:cubicBezTo>
                      <a:cubicBezTo>
                        <a:pt x="2345" y="290733"/>
                        <a:pt x="638" y="194419"/>
                        <a:pt x="7034" y="98474"/>
                      </a:cubicBezTo>
                      <a:cubicBezTo>
                        <a:pt x="7732" y="88012"/>
                        <a:pt x="16972" y="79976"/>
                        <a:pt x="21102" y="70338"/>
                      </a:cubicBezTo>
                      <a:cubicBezTo>
                        <a:pt x="24022" y="63523"/>
                        <a:pt x="23503" y="55026"/>
                        <a:pt x="28135" y="49237"/>
                      </a:cubicBezTo>
                      <a:cubicBezTo>
                        <a:pt x="51188" y="20421"/>
                        <a:pt x="57443" y="8206"/>
                        <a:pt x="63305" y="0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ja-JP" altLang="en-US"/>
                </a:p>
              </p:txBody>
            </p:sp>
            <p:sp>
              <p:nvSpPr>
                <p:cNvPr id="227" name="テキスト ボックス 86"/>
                <p:cNvSpPr txBox="1">
                  <a:spLocks noChangeArrowheads="1"/>
                </p:cNvSpPr>
                <p:nvPr/>
              </p:nvSpPr>
              <p:spPr bwMode="auto">
                <a:xfrm>
                  <a:off x="2584638" y="6339358"/>
                  <a:ext cx="2640935" cy="584007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algn="ctr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r>
                    <a:rPr lang="en-US" altLang="ja-JP" sz="1200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r>
                    <a:rPr lang="en-US" altLang="ja-JP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 (+A</a:t>
                  </a:r>
                  <a:r>
                    <a:rPr lang="en-US" altLang="ja-JP" sz="1200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r>
                    <a:rPr lang="en-US" altLang="ja-JP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) from A</a:t>
                  </a:r>
                  <a:r>
                    <a:rPr lang="en-US" altLang="ja-JP" sz="1200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r>
                    <a:rPr lang="en-US" altLang="ja-JP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: </a:t>
                  </a:r>
                  <a:endParaRPr lang="en-US" altLang="ja-JP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.2</a:t>
                  </a:r>
                  <a:r>
                    <a:rPr lang="en-US" altLang="ja-JP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%</a:t>
                  </a:r>
                  <a:endParaRPr lang="ja-JP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12" name="コンテンツ プレースホルダー 7"/>
            <p:cNvSpPr txBox="1">
              <a:spLocks/>
            </p:cNvSpPr>
            <p:nvPr/>
          </p:nvSpPr>
          <p:spPr bwMode="auto">
            <a:xfrm>
              <a:off x="2414317" y="3530972"/>
              <a:ext cx="496884" cy="4159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noAutofit/>
            </a:bodyPr>
            <a:lstStyle>
              <a:lvl1pPr marL="228600" indent="-228600" algn="l" rtl="0" fontAlgn="base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ctr" eaLnBrk="1" fontAlgn="auto" hangingPunct="1">
                <a:spcAft>
                  <a:spcPts val="0"/>
                </a:spcAft>
                <a:buFont typeface="Arial" panose="020B0604020202020204" pitchFamily="34" charset="0"/>
                <a:buNone/>
                <a:defRPr/>
              </a:pPr>
              <a:r>
                <a:rPr lang="en-US" altLang="ja-JP" sz="2600" dirty="0" smtClean="0"/>
                <a:t>d</a:t>
              </a:r>
              <a:endParaRPr lang="ja-JP" altLang="en-US" sz="2600" dirty="0"/>
            </a:p>
          </p:txBody>
        </p:sp>
        <p:sp>
          <p:nvSpPr>
            <p:cNvPr id="213" name="テキスト ボックス 101"/>
            <p:cNvSpPr txBox="1">
              <a:spLocks noChangeArrowheads="1"/>
            </p:cNvSpPr>
            <p:nvPr/>
          </p:nvSpPr>
          <p:spPr bwMode="auto">
            <a:xfrm>
              <a:off x="3306582" y="3669262"/>
              <a:ext cx="1238805" cy="335520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. sup type</a:t>
              </a:r>
              <a:endParaRPr lang="ja-JP" alt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8" name="グループ化 12325"/>
          <p:cNvGrpSpPr>
            <a:grpSpLocks noChangeAspect="1"/>
          </p:cNvGrpSpPr>
          <p:nvPr/>
        </p:nvGrpSpPr>
        <p:grpSpPr bwMode="auto">
          <a:xfrm>
            <a:off x="1330285" y="5571756"/>
            <a:ext cx="2336227" cy="2698345"/>
            <a:chOff x="5555052" y="3558638"/>
            <a:chExt cx="2737597" cy="3161927"/>
          </a:xfrm>
        </p:grpSpPr>
        <p:grpSp>
          <p:nvGrpSpPr>
            <p:cNvPr id="229" name="グループ化 7167"/>
            <p:cNvGrpSpPr>
              <a:grpSpLocks/>
            </p:cNvGrpSpPr>
            <p:nvPr/>
          </p:nvGrpSpPr>
          <p:grpSpPr bwMode="auto">
            <a:xfrm>
              <a:off x="5645254" y="3946525"/>
              <a:ext cx="2647395" cy="2321858"/>
              <a:chOff x="7023204" y="3783013"/>
              <a:chExt cx="2647395" cy="2321858"/>
            </a:xfrm>
          </p:grpSpPr>
          <p:pic>
            <p:nvPicPr>
              <p:cNvPr id="233" name="図 5"/>
              <p:cNvPicPr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51" t="8916" r="4184" b="10215"/>
              <a:stretch/>
            </p:blipFill>
            <p:spPr bwMode="auto">
              <a:xfrm>
                <a:off x="7139506" y="3798225"/>
                <a:ext cx="2531093" cy="21936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34" name="正方形/長方形 233"/>
              <p:cNvSpPr/>
              <p:nvPr/>
            </p:nvSpPr>
            <p:spPr>
              <a:xfrm>
                <a:off x="9013973" y="4597401"/>
                <a:ext cx="107950" cy="1079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235" name="二等辺三角形 234"/>
              <p:cNvSpPr/>
              <p:nvPr/>
            </p:nvSpPr>
            <p:spPr>
              <a:xfrm>
                <a:off x="8296275" y="5457826"/>
                <a:ext cx="107950" cy="10795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236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8274148" y="4016229"/>
                <a:ext cx="458788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237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7990212" y="4933804"/>
                <a:ext cx="460375" cy="4016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238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7918304" y="5704821"/>
                <a:ext cx="458787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239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7093463" y="3783013"/>
                <a:ext cx="711200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2</a:t>
                </a:r>
                <a:r>
                  <a:rPr lang="en-US" altLang="ja-JP" sz="160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 </a:t>
                </a:r>
                <a:endParaRPr lang="ja-JP" altLang="ja-JP" sz="160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0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7052039" y="5250416"/>
                <a:ext cx="599858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2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b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1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7023204" y="5626852"/>
                <a:ext cx="530269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6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42" name="直線コネクタ 241"/>
              <p:cNvCxnSpPr/>
              <p:nvPr/>
            </p:nvCxnSpPr>
            <p:spPr>
              <a:xfrm>
                <a:off x="7594029" y="3972649"/>
                <a:ext cx="795339" cy="19526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3" name="直線コネクタ 242"/>
              <p:cNvCxnSpPr/>
              <p:nvPr/>
            </p:nvCxnSpPr>
            <p:spPr>
              <a:xfrm flipV="1">
                <a:off x="7553472" y="5130752"/>
                <a:ext cx="558800" cy="32861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直線コネクタ 243"/>
              <p:cNvCxnSpPr/>
              <p:nvPr/>
            </p:nvCxnSpPr>
            <p:spPr>
              <a:xfrm>
                <a:off x="7403475" y="5831906"/>
                <a:ext cx="625474" cy="3939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0" name="テキスト ボックス 87"/>
            <p:cNvSpPr txBox="1">
              <a:spLocks noChangeArrowheads="1"/>
            </p:cNvSpPr>
            <p:nvPr/>
          </p:nvSpPr>
          <p:spPr bwMode="auto">
            <a:xfrm>
              <a:off x="5758524" y="6179585"/>
              <a:ext cx="2531093" cy="54098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from 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from </a:t>
              </a:r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.rec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2.7%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コンテンツ プレースホルダー 7"/>
            <p:cNvSpPr txBox="1">
              <a:spLocks/>
            </p:cNvSpPr>
            <p:nvPr/>
          </p:nvSpPr>
          <p:spPr bwMode="auto">
            <a:xfrm>
              <a:off x="5555052" y="3558638"/>
              <a:ext cx="496889" cy="4159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noAutofit/>
            </a:bodyPr>
            <a:lstStyle>
              <a:lvl1pPr marL="228600" indent="-228600" algn="l" rtl="0" fontAlgn="base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ctr" eaLnBrk="1" fontAlgn="auto" hangingPunct="1">
                <a:spcAft>
                  <a:spcPts val="0"/>
                </a:spcAft>
                <a:buFont typeface="Arial" panose="020B0604020202020204" pitchFamily="34" charset="0"/>
                <a:buNone/>
                <a:defRPr/>
              </a:pPr>
              <a:r>
                <a:rPr lang="en-US" altLang="ja-JP" sz="2600" dirty="0" smtClean="0"/>
                <a:t>e</a:t>
              </a:r>
              <a:endParaRPr lang="ja-JP" altLang="en-US" sz="2600" dirty="0"/>
            </a:p>
          </p:txBody>
        </p:sp>
        <p:sp>
          <p:nvSpPr>
            <p:cNvPr id="232" name="テキスト ボックス 102"/>
            <p:cNvSpPr txBox="1">
              <a:spLocks noChangeArrowheads="1"/>
            </p:cNvSpPr>
            <p:nvPr/>
          </p:nvSpPr>
          <p:spPr bwMode="auto">
            <a:xfrm>
              <a:off x="6216523" y="3682726"/>
              <a:ext cx="1754995" cy="324588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. </a:t>
              </a:r>
              <a:r>
                <a:rPr lang="en-US" altLang="ja-JP" sz="1200" b="1" u="sng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+A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ja-JP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sc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ype</a:t>
              </a:r>
              <a:endParaRPr lang="ja-JP" alt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46" name="図 17"/>
          <p:cNvPicPr>
            <a:picLocks/>
          </p:cNvPicPr>
          <p:nvPr/>
        </p:nvPicPr>
        <p:blipFill rotWithShape="1">
          <a:blip r:embed="rId4">
            <a:clrChange>
              <a:clrFrom>
                <a:srgbClr val="EEEEEE"/>
              </a:clrFrom>
              <a:clrTo>
                <a:srgbClr val="EEEEE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4" t="5275" r="9740" b="15746"/>
          <a:stretch/>
        </p:blipFill>
        <p:spPr bwMode="auto">
          <a:xfrm>
            <a:off x="3859193" y="5915747"/>
            <a:ext cx="2160001" cy="1871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7" name="正方形/長方形 246"/>
          <p:cNvSpPr/>
          <p:nvPr/>
        </p:nvSpPr>
        <p:spPr bwMode="auto">
          <a:xfrm>
            <a:off x="5552127" y="7116770"/>
            <a:ext cx="74340" cy="756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48" name="テキスト ボックス 33"/>
          <p:cNvSpPr txBox="1">
            <a:spLocks noChangeArrowheads="1"/>
          </p:cNvSpPr>
          <p:nvPr/>
        </p:nvSpPr>
        <p:spPr bwMode="auto">
          <a:xfrm>
            <a:off x="4699838" y="7438537"/>
            <a:ext cx="383646" cy="3345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ja-JP" altLang="en-US" sz="2000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249" name="テキスト ボックス 33"/>
          <p:cNvSpPr txBox="1">
            <a:spLocks noChangeArrowheads="1"/>
          </p:cNvSpPr>
          <p:nvPr/>
        </p:nvSpPr>
        <p:spPr bwMode="auto">
          <a:xfrm>
            <a:off x="4662707" y="6955547"/>
            <a:ext cx="383646" cy="3345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ja-JP" altLang="en-US" sz="200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250" name="テキスト ボックス 38927"/>
          <p:cNvSpPr txBox="1">
            <a:spLocks noChangeArrowheads="1"/>
          </p:cNvSpPr>
          <p:nvPr/>
        </p:nvSpPr>
        <p:spPr bwMode="auto">
          <a:xfrm>
            <a:off x="4191049" y="7242751"/>
            <a:ext cx="416833" cy="3610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just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6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6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endParaRPr lang="ja-JP" altLang="ja-JP" sz="16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cxnSp>
        <p:nvCxnSpPr>
          <p:cNvPr id="251" name="直線コネクタ 250"/>
          <p:cNvCxnSpPr/>
          <p:nvPr/>
        </p:nvCxnSpPr>
        <p:spPr bwMode="auto">
          <a:xfrm>
            <a:off x="4514532" y="7420419"/>
            <a:ext cx="288000" cy="15266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テキスト ボックス 38927"/>
          <p:cNvSpPr txBox="1">
            <a:spLocks noChangeArrowheads="1"/>
          </p:cNvSpPr>
          <p:nvPr/>
        </p:nvSpPr>
        <p:spPr bwMode="auto">
          <a:xfrm>
            <a:off x="4363858" y="5946025"/>
            <a:ext cx="488904" cy="3610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just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6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 </a:t>
            </a:r>
            <a:endParaRPr lang="ja-JP" altLang="ja-JP" sz="16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53" name="テキスト ボックス 33"/>
          <p:cNvSpPr txBox="1">
            <a:spLocks noChangeArrowheads="1"/>
          </p:cNvSpPr>
          <p:nvPr/>
        </p:nvSpPr>
        <p:spPr bwMode="auto">
          <a:xfrm>
            <a:off x="4782414" y="6866838"/>
            <a:ext cx="383645" cy="3345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ja-JP" altLang="en-US" sz="2000" dirty="0">
                <a:solidFill>
                  <a:schemeClr val="bg1"/>
                </a:solidFill>
              </a:rPr>
              <a:t>*</a:t>
            </a:r>
          </a:p>
        </p:txBody>
      </p:sp>
      <p:cxnSp>
        <p:nvCxnSpPr>
          <p:cNvPr id="254" name="直線コネクタ 253"/>
          <p:cNvCxnSpPr/>
          <p:nvPr/>
        </p:nvCxnSpPr>
        <p:spPr bwMode="auto">
          <a:xfrm>
            <a:off x="4656767" y="6224798"/>
            <a:ext cx="262845" cy="75003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5" name="テキスト ボックス 38927"/>
          <p:cNvSpPr txBox="1">
            <a:spLocks noChangeArrowheads="1"/>
          </p:cNvSpPr>
          <p:nvPr/>
        </p:nvSpPr>
        <p:spPr bwMode="auto">
          <a:xfrm>
            <a:off x="3896744" y="7029722"/>
            <a:ext cx="594717" cy="3610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just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6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600" baseline="300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6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 </a:t>
            </a:r>
            <a:endParaRPr lang="ja-JP" altLang="ja-JP" sz="160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cxnSp>
        <p:nvCxnSpPr>
          <p:cNvPr id="256" name="直線コネクタ 255"/>
          <p:cNvCxnSpPr/>
          <p:nvPr/>
        </p:nvCxnSpPr>
        <p:spPr bwMode="auto">
          <a:xfrm flipV="1">
            <a:off x="4318887" y="7122647"/>
            <a:ext cx="431435" cy="5442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7" name="テキスト ボックス 87"/>
          <p:cNvSpPr txBox="1">
            <a:spLocks noChangeArrowheads="1"/>
          </p:cNvSpPr>
          <p:nvPr/>
        </p:nvSpPr>
        <p:spPr bwMode="auto">
          <a:xfrm>
            <a:off x="3859111" y="7808583"/>
            <a:ext cx="2160001" cy="46166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+A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from A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3%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コンテンツ プレースホルダー 7"/>
          <p:cNvSpPr txBox="1">
            <a:spLocks/>
          </p:cNvSpPr>
          <p:nvPr/>
        </p:nvSpPr>
        <p:spPr bwMode="auto">
          <a:xfrm>
            <a:off x="3780125" y="5556622"/>
            <a:ext cx="415506" cy="3478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 marL="228600" indent="-228600" algn="l" rtl="0" fontAlgn="base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rtl="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 eaLnBrk="1" fontAlgn="auto" hangingPunct="1"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2600" dirty="0"/>
              <a:t>f</a:t>
            </a:r>
            <a:endParaRPr lang="ja-JP" altLang="en-US" sz="2600" dirty="0"/>
          </a:p>
        </p:txBody>
      </p:sp>
      <p:sp>
        <p:nvSpPr>
          <p:cNvPr id="259" name="二等辺三角形 258"/>
          <p:cNvSpPr/>
          <p:nvPr/>
        </p:nvSpPr>
        <p:spPr bwMode="auto">
          <a:xfrm>
            <a:off x="5046353" y="7300531"/>
            <a:ext cx="90270" cy="90269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60" name="テキスト ボックス 105"/>
          <p:cNvSpPr txBox="1">
            <a:spLocks noChangeArrowheads="1"/>
          </p:cNvSpPr>
          <p:nvPr/>
        </p:nvSpPr>
        <p:spPr bwMode="auto">
          <a:xfrm>
            <a:off x="4306456" y="5675084"/>
            <a:ext cx="1523774" cy="277002"/>
          </a:xfrm>
          <a:prstGeom prst="rect">
            <a:avLst/>
          </a:prstGeom>
          <a:noFill/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. </a:t>
            </a:r>
            <a:r>
              <a:rPr lang="en-US" altLang="ja-JP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+A</a:t>
            </a:r>
            <a:r>
              <a:rPr lang="en-US" altLang="ja-JP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20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c</a:t>
            </a:r>
            <a:r>
              <a:rPr lang="en-US" altLang="ja-JP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e</a:t>
            </a:r>
            <a:endParaRPr lang="ja-JP" altLang="en-US" sz="12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2" name="図 16"/>
          <p:cNvPicPr>
            <a:picLocks/>
          </p:cNvPicPr>
          <p:nvPr/>
        </p:nvPicPr>
        <p:blipFill rotWithShape="1">
          <a:blip r:embed="rId5">
            <a:clrChange>
              <a:clrFrom>
                <a:srgbClr val="E8E8E8"/>
              </a:clrFrom>
              <a:clrTo>
                <a:srgbClr val="E8E8E8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8" t="12194" b="7179"/>
          <a:stretch/>
        </p:blipFill>
        <p:spPr bwMode="auto">
          <a:xfrm>
            <a:off x="1516053" y="3258339"/>
            <a:ext cx="2160005" cy="1871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63" name="グループ化 14"/>
          <p:cNvGrpSpPr>
            <a:grpSpLocks/>
          </p:cNvGrpSpPr>
          <p:nvPr/>
        </p:nvGrpSpPr>
        <p:grpSpPr bwMode="auto">
          <a:xfrm>
            <a:off x="1384992" y="2861019"/>
            <a:ext cx="2283304" cy="2747831"/>
            <a:chOff x="8329019" y="153993"/>
            <a:chExt cx="2978281" cy="3585910"/>
          </a:xfrm>
        </p:grpSpPr>
        <p:grpSp>
          <p:nvGrpSpPr>
            <p:cNvPr id="264" name="グループ化 19"/>
            <p:cNvGrpSpPr>
              <a:grpSpLocks/>
            </p:cNvGrpSpPr>
            <p:nvPr/>
          </p:nvGrpSpPr>
          <p:grpSpPr bwMode="auto">
            <a:xfrm>
              <a:off x="8399500" y="299004"/>
              <a:ext cx="2266510" cy="2574071"/>
              <a:chOff x="8398988" y="185973"/>
              <a:chExt cx="2266312" cy="2573545"/>
            </a:xfrm>
          </p:grpSpPr>
          <p:sp>
            <p:nvSpPr>
              <p:cNvPr id="268" name="フリーフォーム 267"/>
              <p:cNvSpPr/>
              <p:nvPr/>
            </p:nvSpPr>
            <p:spPr bwMode="auto">
              <a:xfrm>
                <a:off x="8398988" y="185973"/>
                <a:ext cx="822094" cy="803340"/>
              </a:xfrm>
              <a:custGeom>
                <a:avLst/>
                <a:gdLst>
                  <a:gd name="connsiteX0" fmla="*/ 30480 w 840368"/>
                  <a:gd name="connsiteY0" fmla="*/ 0 h 823107"/>
                  <a:gd name="connsiteX1" fmla="*/ 30480 w 840368"/>
                  <a:gd name="connsiteY1" fmla="*/ 0 h 823107"/>
                  <a:gd name="connsiteX2" fmla="*/ 396240 w 840368"/>
                  <a:gd name="connsiteY2" fmla="*/ 30480 h 823107"/>
                  <a:gd name="connsiteX3" fmla="*/ 640080 w 840368"/>
                  <a:gd name="connsiteY3" fmla="*/ 45720 h 823107"/>
                  <a:gd name="connsiteX4" fmla="*/ 731520 w 840368"/>
                  <a:gd name="connsiteY4" fmla="*/ 91440 h 823107"/>
                  <a:gd name="connsiteX5" fmla="*/ 762000 w 840368"/>
                  <a:gd name="connsiteY5" fmla="*/ 137160 h 823107"/>
                  <a:gd name="connsiteX6" fmla="*/ 792480 w 840368"/>
                  <a:gd name="connsiteY6" fmla="*/ 243840 h 823107"/>
                  <a:gd name="connsiteX7" fmla="*/ 822960 w 840368"/>
                  <a:gd name="connsiteY7" fmla="*/ 289560 h 823107"/>
                  <a:gd name="connsiteX8" fmla="*/ 822960 w 840368"/>
                  <a:gd name="connsiteY8" fmla="*/ 548640 h 823107"/>
                  <a:gd name="connsiteX9" fmla="*/ 792480 w 840368"/>
                  <a:gd name="connsiteY9" fmla="*/ 640080 h 823107"/>
                  <a:gd name="connsiteX10" fmla="*/ 701040 w 840368"/>
                  <a:gd name="connsiteY10" fmla="*/ 716280 h 823107"/>
                  <a:gd name="connsiteX11" fmla="*/ 487680 w 840368"/>
                  <a:gd name="connsiteY11" fmla="*/ 777240 h 823107"/>
                  <a:gd name="connsiteX12" fmla="*/ 381000 w 840368"/>
                  <a:gd name="connsiteY12" fmla="*/ 792480 h 823107"/>
                  <a:gd name="connsiteX13" fmla="*/ 304800 w 840368"/>
                  <a:gd name="connsiteY13" fmla="*/ 807720 h 823107"/>
                  <a:gd name="connsiteX14" fmla="*/ 0 w 840368"/>
                  <a:gd name="connsiteY14" fmla="*/ 822960 h 823107"/>
                  <a:gd name="connsiteX15" fmla="*/ 0 w 840368"/>
                  <a:gd name="connsiteY15" fmla="*/ 822960 h 82310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</a:cxnLst>
                <a:rect l="l" t="t" r="r" b="b"/>
                <a:pathLst>
                  <a:path w="840368" h="823107">
                    <a:moveTo>
                      <a:pt x="30480" y="0"/>
                    </a:moveTo>
                    <a:lnTo>
                      <a:pt x="30480" y="0"/>
                    </a:lnTo>
                    <a:cubicBezTo>
                      <a:pt x="186033" y="14141"/>
                      <a:pt x="234308" y="19312"/>
                      <a:pt x="396240" y="30480"/>
                    </a:cubicBezTo>
                    <a:lnTo>
                      <a:pt x="640080" y="45720"/>
                    </a:lnTo>
                    <a:cubicBezTo>
                      <a:pt x="677265" y="58115"/>
                      <a:pt x="701977" y="61897"/>
                      <a:pt x="731520" y="91440"/>
                    </a:cubicBezTo>
                    <a:cubicBezTo>
                      <a:pt x="744472" y="104392"/>
                      <a:pt x="751840" y="121920"/>
                      <a:pt x="762000" y="137160"/>
                    </a:cubicBezTo>
                    <a:cubicBezTo>
                      <a:pt x="766883" y="156692"/>
                      <a:pt x="781548" y="221976"/>
                      <a:pt x="792480" y="243840"/>
                    </a:cubicBezTo>
                    <a:cubicBezTo>
                      <a:pt x="800671" y="260223"/>
                      <a:pt x="812800" y="274320"/>
                      <a:pt x="822960" y="289560"/>
                    </a:cubicBezTo>
                    <a:cubicBezTo>
                      <a:pt x="842883" y="409101"/>
                      <a:pt x="849243" y="399701"/>
                      <a:pt x="822960" y="548640"/>
                    </a:cubicBezTo>
                    <a:cubicBezTo>
                      <a:pt x="817376" y="580280"/>
                      <a:pt x="815198" y="617362"/>
                      <a:pt x="792480" y="640080"/>
                    </a:cubicBezTo>
                    <a:cubicBezTo>
                      <a:pt x="763769" y="668791"/>
                      <a:pt x="739232" y="699306"/>
                      <a:pt x="701040" y="716280"/>
                    </a:cubicBezTo>
                    <a:cubicBezTo>
                      <a:pt x="659902" y="734564"/>
                      <a:pt x="523368" y="772142"/>
                      <a:pt x="487680" y="777240"/>
                    </a:cubicBezTo>
                    <a:cubicBezTo>
                      <a:pt x="452120" y="782320"/>
                      <a:pt x="416432" y="786575"/>
                      <a:pt x="381000" y="792480"/>
                    </a:cubicBezTo>
                    <a:cubicBezTo>
                      <a:pt x="355449" y="796738"/>
                      <a:pt x="330545" y="804859"/>
                      <a:pt x="304800" y="807720"/>
                    </a:cubicBezTo>
                    <a:cubicBezTo>
                      <a:pt x="143094" y="825687"/>
                      <a:pt x="134330" y="822960"/>
                      <a:pt x="0" y="822960"/>
                    </a:cubicBezTo>
                    <a:lnTo>
                      <a:pt x="0" y="822960"/>
                    </a:lnTo>
                  </a:path>
                </a:pathLst>
              </a:cu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sp>
            <p:nvSpPr>
              <p:cNvPr id="269" name="正方形/長方形 268"/>
              <p:cNvSpPr/>
              <p:nvPr/>
            </p:nvSpPr>
            <p:spPr>
              <a:xfrm>
                <a:off x="10557380" y="2080013"/>
                <a:ext cx="107920" cy="10795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270" name="二等辺三角形 269"/>
              <p:cNvSpPr/>
              <p:nvPr/>
            </p:nvSpPr>
            <p:spPr>
              <a:xfrm>
                <a:off x="10071742" y="2651559"/>
                <a:ext cx="107920" cy="107959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271" name="円/楕円 270"/>
              <p:cNvSpPr>
                <a:spLocks/>
              </p:cNvSpPr>
              <p:nvPr/>
            </p:nvSpPr>
            <p:spPr>
              <a:xfrm>
                <a:off x="10319596" y="2534842"/>
                <a:ext cx="107920" cy="107959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sp>
            <p:nvSpPr>
              <p:cNvPr id="272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9536644" y="1070494"/>
                <a:ext cx="460375" cy="4000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273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9348339" y="1460555"/>
                <a:ext cx="458788" cy="4000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274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8790845" y="2086763"/>
                <a:ext cx="711199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2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b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75" name="直線コネクタ 5145"/>
              <p:cNvCxnSpPr/>
              <p:nvPr/>
            </p:nvCxnSpPr>
            <p:spPr>
              <a:xfrm>
                <a:off x="9028291" y="926214"/>
                <a:ext cx="657797" cy="32295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直線コネクタ 5147"/>
              <p:cNvCxnSpPr/>
              <p:nvPr/>
            </p:nvCxnSpPr>
            <p:spPr>
              <a:xfrm flipV="1">
                <a:off x="9167606" y="1686775"/>
                <a:ext cx="338042" cy="463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7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8500609" y="600461"/>
                <a:ext cx="711199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2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65" name="テキスト ボックス 85"/>
            <p:cNvSpPr txBox="1">
              <a:spLocks noChangeArrowheads="1"/>
            </p:cNvSpPr>
            <p:nvPr/>
          </p:nvSpPr>
          <p:spPr bwMode="auto">
            <a:xfrm>
              <a:off x="8489850" y="3137432"/>
              <a:ext cx="2817450" cy="602471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+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from A. rec: </a:t>
              </a:r>
              <a:endPara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.8%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コンテンツ プレースホルダー 7"/>
            <p:cNvSpPr txBox="1">
              <a:spLocks/>
            </p:cNvSpPr>
            <p:nvPr/>
          </p:nvSpPr>
          <p:spPr bwMode="auto">
            <a:xfrm>
              <a:off x="8329019" y="153993"/>
              <a:ext cx="426392" cy="392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noAutofit/>
            </a:bodyPr>
            <a:lstStyle>
              <a:lvl1pPr marL="228600" indent="-228600" algn="l" rtl="0" fontAlgn="base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ctr" eaLnBrk="1" fontAlgn="auto" hangingPunct="1">
                <a:spcAft>
                  <a:spcPts val="0"/>
                </a:spcAft>
                <a:buFont typeface="Arial" panose="020B0604020202020204" pitchFamily="34" charset="0"/>
                <a:buNone/>
                <a:defRPr/>
              </a:pPr>
              <a:r>
                <a:rPr lang="en-US" altLang="ja-JP" sz="2600" dirty="0" smtClean="0"/>
                <a:t>c</a:t>
              </a:r>
              <a:endParaRPr lang="ja-JP" altLang="en-US" sz="2600" dirty="0"/>
            </a:p>
          </p:txBody>
        </p:sp>
        <p:sp>
          <p:nvSpPr>
            <p:cNvPr id="267" name="テキスト ボックス 99"/>
            <p:cNvSpPr txBox="1">
              <a:spLocks noChangeArrowheads="1"/>
            </p:cNvSpPr>
            <p:nvPr/>
          </p:nvSpPr>
          <p:spPr bwMode="auto">
            <a:xfrm>
              <a:off x="8748277" y="349970"/>
              <a:ext cx="2534707" cy="361483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. </a:t>
              </a:r>
              <a:r>
                <a:rPr lang="en-US" altLang="ja-JP" sz="1200" b="1" u="sng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+Tr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ja-JP" sz="1200" b="1" u="sng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f+A</a:t>
              </a:r>
              <a:r>
                <a:rPr lang="en-US" altLang="ja-JP" sz="1200" b="1" u="sng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ja-JP" sz="1200" b="1" u="sng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c</a:t>
              </a:r>
              <a:r>
                <a:rPr lang="en-US" altLang="ja-JP" sz="1200" b="1" u="sng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b="1" u="sng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ype</a:t>
              </a:r>
              <a:endParaRPr lang="ja-JP" alt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78" name="グループ化 17"/>
          <p:cNvGrpSpPr>
            <a:grpSpLocks noChangeAspect="1"/>
          </p:cNvGrpSpPr>
          <p:nvPr/>
        </p:nvGrpSpPr>
        <p:grpSpPr bwMode="auto">
          <a:xfrm>
            <a:off x="3738959" y="91707"/>
            <a:ext cx="2464971" cy="2751849"/>
            <a:chOff x="5352282" y="84135"/>
            <a:chExt cx="3083690" cy="3442574"/>
          </a:xfrm>
        </p:grpSpPr>
        <p:sp>
          <p:nvSpPr>
            <p:cNvPr id="279" name="フリーフォーム 278"/>
            <p:cNvSpPr/>
            <p:nvPr/>
          </p:nvSpPr>
          <p:spPr>
            <a:xfrm>
              <a:off x="6773863" y="871538"/>
              <a:ext cx="260350" cy="354012"/>
            </a:xfrm>
            <a:custGeom>
              <a:avLst/>
              <a:gdLst>
                <a:gd name="connsiteX0" fmla="*/ 187508 w 259914"/>
                <a:gd name="connsiteY0" fmla="*/ 354601 h 354601"/>
                <a:gd name="connsiteX1" fmla="*/ 187508 w 259914"/>
                <a:gd name="connsiteY1" fmla="*/ 354601 h 354601"/>
                <a:gd name="connsiteX2" fmla="*/ 125163 w 259914"/>
                <a:gd name="connsiteY2" fmla="*/ 281865 h 354601"/>
                <a:gd name="connsiteX3" fmla="*/ 104381 w 259914"/>
                <a:gd name="connsiteY3" fmla="*/ 250692 h 354601"/>
                <a:gd name="connsiteX4" fmla="*/ 42035 w 259914"/>
                <a:gd name="connsiteY4" fmla="*/ 198738 h 354601"/>
                <a:gd name="connsiteX5" fmla="*/ 472 w 259914"/>
                <a:gd name="connsiteY5" fmla="*/ 136392 h 354601"/>
                <a:gd name="connsiteX6" fmla="*/ 42035 w 259914"/>
                <a:gd name="connsiteY6" fmla="*/ 1310 h 354601"/>
                <a:gd name="connsiteX7" fmla="*/ 145944 w 259914"/>
                <a:gd name="connsiteY7" fmla="*/ 11701 h 354601"/>
                <a:gd name="connsiteX8" fmla="*/ 177117 w 259914"/>
                <a:gd name="connsiteY8" fmla="*/ 22092 h 354601"/>
                <a:gd name="connsiteX9" fmla="*/ 239463 w 259914"/>
                <a:gd name="connsiteY9" fmla="*/ 53265 h 354601"/>
                <a:gd name="connsiteX10" fmla="*/ 249854 w 259914"/>
                <a:gd name="connsiteY10" fmla="*/ 354601 h 354601"/>
                <a:gd name="connsiteX11" fmla="*/ 249854 w 259914"/>
                <a:gd name="connsiteY11" fmla="*/ 354601 h 35460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259914" h="354601">
                  <a:moveTo>
                    <a:pt x="187508" y="354601"/>
                  </a:moveTo>
                  <a:lnTo>
                    <a:pt x="187508" y="354601"/>
                  </a:lnTo>
                  <a:cubicBezTo>
                    <a:pt x="166726" y="330356"/>
                    <a:pt x="145111" y="306800"/>
                    <a:pt x="125163" y="281865"/>
                  </a:cubicBezTo>
                  <a:cubicBezTo>
                    <a:pt x="117362" y="272113"/>
                    <a:pt x="113212" y="259523"/>
                    <a:pt x="104381" y="250692"/>
                  </a:cubicBezTo>
                  <a:cubicBezTo>
                    <a:pt x="44350" y="190661"/>
                    <a:pt x="101609" y="275333"/>
                    <a:pt x="42035" y="198738"/>
                  </a:cubicBezTo>
                  <a:cubicBezTo>
                    <a:pt x="26701" y="179023"/>
                    <a:pt x="472" y="136392"/>
                    <a:pt x="472" y="136392"/>
                  </a:cubicBezTo>
                  <a:cubicBezTo>
                    <a:pt x="969" y="131426"/>
                    <a:pt x="-8956" y="9155"/>
                    <a:pt x="42035" y="1310"/>
                  </a:cubicBezTo>
                  <a:cubicBezTo>
                    <a:pt x="76439" y="-3983"/>
                    <a:pt x="111308" y="8237"/>
                    <a:pt x="145944" y="11701"/>
                  </a:cubicBezTo>
                  <a:cubicBezTo>
                    <a:pt x="156335" y="15165"/>
                    <a:pt x="167320" y="17194"/>
                    <a:pt x="177117" y="22092"/>
                  </a:cubicBezTo>
                  <a:cubicBezTo>
                    <a:pt x="257690" y="62379"/>
                    <a:pt x="161109" y="27147"/>
                    <a:pt x="239463" y="53265"/>
                  </a:cubicBezTo>
                  <a:cubicBezTo>
                    <a:pt x="278332" y="169871"/>
                    <a:pt x="249854" y="73485"/>
                    <a:pt x="249854" y="354601"/>
                  </a:cubicBezTo>
                  <a:lnTo>
                    <a:pt x="249854" y="354601"/>
                  </a:lnTo>
                </a:path>
              </a:pathLst>
            </a:cu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280" name="フリーフォーム 279"/>
            <p:cNvSpPr/>
            <p:nvPr/>
          </p:nvSpPr>
          <p:spPr>
            <a:xfrm>
              <a:off x="7213600" y="914400"/>
              <a:ext cx="153988" cy="260350"/>
            </a:xfrm>
            <a:custGeom>
              <a:avLst/>
              <a:gdLst>
                <a:gd name="connsiteX0" fmla="*/ 154112 w 154112"/>
                <a:gd name="connsiteY0" fmla="*/ 145473 h 259773"/>
                <a:gd name="connsiteX1" fmla="*/ 154112 w 154112"/>
                <a:gd name="connsiteY1" fmla="*/ 145473 h 259773"/>
                <a:gd name="connsiteX2" fmla="*/ 70984 w 154112"/>
                <a:gd name="connsiteY2" fmla="*/ 249382 h 259773"/>
                <a:gd name="connsiteX3" fmla="*/ 39812 w 154112"/>
                <a:gd name="connsiteY3" fmla="*/ 259773 h 259773"/>
                <a:gd name="connsiteX4" fmla="*/ 29421 w 154112"/>
                <a:gd name="connsiteY4" fmla="*/ 10391 h 259773"/>
                <a:gd name="connsiteX5" fmla="*/ 60593 w 154112"/>
                <a:gd name="connsiteY5" fmla="*/ 0 h 259773"/>
                <a:gd name="connsiteX6" fmla="*/ 91766 w 154112"/>
                <a:gd name="connsiteY6" fmla="*/ 51954 h 259773"/>
                <a:gd name="connsiteX7" fmla="*/ 91766 w 154112"/>
                <a:gd name="connsiteY7" fmla="*/ 51954 h 25977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54112" h="259773">
                  <a:moveTo>
                    <a:pt x="154112" y="145473"/>
                  </a:moveTo>
                  <a:lnTo>
                    <a:pt x="154112" y="145473"/>
                  </a:lnTo>
                  <a:cubicBezTo>
                    <a:pt x="141763" y="162762"/>
                    <a:pt x="99479" y="230385"/>
                    <a:pt x="70984" y="249382"/>
                  </a:cubicBezTo>
                  <a:cubicBezTo>
                    <a:pt x="61871" y="255458"/>
                    <a:pt x="50203" y="256309"/>
                    <a:pt x="39812" y="259773"/>
                  </a:cubicBezTo>
                  <a:cubicBezTo>
                    <a:pt x="-17191" y="174268"/>
                    <a:pt x="-5887" y="204589"/>
                    <a:pt x="29421" y="10391"/>
                  </a:cubicBezTo>
                  <a:cubicBezTo>
                    <a:pt x="31380" y="-385"/>
                    <a:pt x="50202" y="3464"/>
                    <a:pt x="60593" y="0"/>
                  </a:cubicBezTo>
                  <a:cubicBezTo>
                    <a:pt x="100412" y="26546"/>
                    <a:pt x="91766" y="8294"/>
                    <a:pt x="91766" y="51954"/>
                  </a:cubicBezTo>
                  <a:lnTo>
                    <a:pt x="91766" y="51954"/>
                  </a:lnTo>
                </a:path>
              </a:pathLst>
            </a:cu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grpSp>
          <p:nvGrpSpPr>
            <p:cNvPr id="281" name="グループ化 17"/>
            <p:cNvGrpSpPr>
              <a:grpSpLocks/>
            </p:cNvGrpSpPr>
            <p:nvPr/>
          </p:nvGrpSpPr>
          <p:grpSpPr bwMode="auto">
            <a:xfrm>
              <a:off x="5468716" y="329601"/>
              <a:ext cx="2967256" cy="2600401"/>
              <a:chOff x="5459026" y="320675"/>
              <a:chExt cx="2967424" cy="2599218"/>
            </a:xfrm>
          </p:grpSpPr>
          <p:grpSp>
            <p:nvGrpSpPr>
              <p:cNvPr id="285" name="グループ化 16"/>
              <p:cNvGrpSpPr>
                <a:grpSpLocks/>
              </p:cNvGrpSpPr>
              <p:nvPr/>
            </p:nvGrpSpPr>
            <p:grpSpPr bwMode="auto">
              <a:xfrm>
                <a:off x="5459026" y="320675"/>
                <a:ext cx="2967424" cy="2599218"/>
                <a:chOff x="5459026" y="320675"/>
                <a:chExt cx="2967424" cy="2599218"/>
              </a:xfrm>
            </p:grpSpPr>
            <p:pic>
              <p:nvPicPr>
                <p:cNvPr id="287" name="図 15"/>
                <p:cNvPicPr>
                  <a:picLocks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9669" r="4865" b="8862"/>
                <a:stretch/>
              </p:blipFill>
              <p:spPr bwMode="auto">
                <a:xfrm>
                  <a:off x="5517736" y="579081"/>
                  <a:ext cx="2702322" cy="23408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288" name="グループ化 4"/>
                <p:cNvGrpSpPr>
                  <a:grpSpLocks/>
                </p:cNvGrpSpPr>
                <p:nvPr/>
              </p:nvGrpSpPr>
              <p:grpSpPr bwMode="auto">
                <a:xfrm>
                  <a:off x="5459026" y="320675"/>
                  <a:ext cx="2967424" cy="2397787"/>
                  <a:chOff x="6830626" y="320675"/>
                  <a:chExt cx="2967424" cy="2397787"/>
                </a:xfrm>
              </p:grpSpPr>
              <p:grpSp>
                <p:nvGrpSpPr>
                  <p:cNvPr id="289" name="グループ化 5126"/>
                  <p:cNvGrpSpPr>
                    <a:grpSpLocks/>
                  </p:cNvGrpSpPr>
                  <p:nvPr/>
                </p:nvGrpSpPr>
                <p:grpSpPr bwMode="auto">
                  <a:xfrm>
                    <a:off x="6918325" y="320675"/>
                    <a:ext cx="2879725" cy="1111250"/>
                    <a:chOff x="6918598" y="320040"/>
                    <a:chExt cx="2926442" cy="1127161"/>
                  </a:xfrm>
                </p:grpSpPr>
                <p:sp>
                  <p:nvSpPr>
                    <p:cNvPr id="297" name="フリーフォーム 296"/>
                    <p:cNvSpPr/>
                    <p:nvPr/>
                  </p:nvSpPr>
                  <p:spPr bwMode="auto">
                    <a:xfrm>
                      <a:off x="6918433" y="320647"/>
                      <a:ext cx="279109" cy="426517"/>
                    </a:xfrm>
                    <a:custGeom>
                      <a:avLst/>
                      <a:gdLst>
                        <a:gd name="connsiteX0" fmla="*/ 362 w 279357"/>
                        <a:gd name="connsiteY0" fmla="*/ 0 h 426720"/>
                        <a:gd name="connsiteX1" fmla="*/ 362 w 279357"/>
                        <a:gd name="connsiteY1" fmla="*/ 0 h 426720"/>
                        <a:gd name="connsiteX2" fmla="*/ 274682 w 279357"/>
                        <a:gd name="connsiteY2" fmla="*/ 350520 h 426720"/>
                        <a:gd name="connsiteX3" fmla="*/ 259442 w 279357"/>
                        <a:gd name="connsiteY3" fmla="*/ 411480 h 426720"/>
                        <a:gd name="connsiteX4" fmla="*/ 183242 w 279357"/>
                        <a:gd name="connsiteY4" fmla="*/ 426720 h 426720"/>
                        <a:gd name="connsiteX5" fmla="*/ 15602 w 279357"/>
                        <a:gd name="connsiteY5" fmla="*/ 411480 h 426720"/>
                        <a:gd name="connsiteX6" fmla="*/ 362 w 279357"/>
                        <a:gd name="connsiteY6" fmla="*/ 350520 h 426720"/>
                        <a:gd name="connsiteX7" fmla="*/ 362 w 279357"/>
                        <a:gd name="connsiteY7" fmla="*/ 350520 h 42672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</a:cxnLst>
                      <a:rect l="l" t="t" r="r" b="b"/>
                      <a:pathLst>
                        <a:path w="279357" h="426720">
                          <a:moveTo>
                            <a:pt x="362" y="0"/>
                          </a:moveTo>
                          <a:lnTo>
                            <a:pt x="362" y="0"/>
                          </a:lnTo>
                          <a:cubicBezTo>
                            <a:pt x="91802" y="116840"/>
                            <a:pt x="195630" y="224967"/>
                            <a:pt x="274682" y="350520"/>
                          </a:cubicBezTo>
                          <a:cubicBezTo>
                            <a:pt x="285842" y="368245"/>
                            <a:pt x="275533" y="398071"/>
                            <a:pt x="259442" y="411480"/>
                          </a:cubicBezTo>
                          <a:cubicBezTo>
                            <a:pt x="239543" y="428063"/>
                            <a:pt x="208642" y="421640"/>
                            <a:pt x="183242" y="426720"/>
                          </a:cubicBezTo>
                          <a:cubicBezTo>
                            <a:pt x="127362" y="421640"/>
                            <a:pt x="67396" y="433061"/>
                            <a:pt x="15602" y="411480"/>
                          </a:cubicBezTo>
                          <a:cubicBezTo>
                            <a:pt x="-3732" y="403424"/>
                            <a:pt x="362" y="350520"/>
                            <a:pt x="362" y="350520"/>
                          </a:cubicBezTo>
                          <a:lnTo>
                            <a:pt x="362" y="350520"/>
                          </a:lnTo>
                        </a:path>
                      </a:pathLst>
                    </a:cu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endParaRPr lang="ja-JP" altLang="en-US"/>
                    </a:p>
                  </p:txBody>
                </p:sp>
                <p:sp>
                  <p:nvSpPr>
                    <p:cNvPr id="298" name="フリーフォーム 297"/>
                    <p:cNvSpPr/>
                    <p:nvPr/>
                  </p:nvSpPr>
                  <p:spPr>
                    <a:xfrm>
                      <a:off x="9357810" y="549196"/>
                      <a:ext cx="487230" cy="898099"/>
                    </a:xfrm>
                    <a:custGeom>
                      <a:avLst/>
                      <a:gdLst>
                        <a:gd name="connsiteX0" fmla="*/ 0 w 487680"/>
                        <a:gd name="connsiteY0" fmla="*/ 640080 h 899160"/>
                        <a:gd name="connsiteX1" fmla="*/ 0 w 487680"/>
                        <a:gd name="connsiteY1" fmla="*/ 640080 h 899160"/>
                        <a:gd name="connsiteX2" fmla="*/ 106680 w 487680"/>
                        <a:gd name="connsiteY2" fmla="*/ 487680 h 899160"/>
                        <a:gd name="connsiteX3" fmla="*/ 137160 w 487680"/>
                        <a:gd name="connsiteY3" fmla="*/ 441960 h 899160"/>
                        <a:gd name="connsiteX4" fmla="*/ 182880 w 487680"/>
                        <a:gd name="connsiteY4" fmla="*/ 350520 h 899160"/>
                        <a:gd name="connsiteX5" fmla="*/ 198120 w 487680"/>
                        <a:gd name="connsiteY5" fmla="*/ 304800 h 899160"/>
                        <a:gd name="connsiteX6" fmla="*/ 228600 w 487680"/>
                        <a:gd name="connsiteY6" fmla="*/ 259080 h 899160"/>
                        <a:gd name="connsiteX7" fmla="*/ 259080 w 487680"/>
                        <a:gd name="connsiteY7" fmla="*/ 167640 h 899160"/>
                        <a:gd name="connsiteX8" fmla="*/ 289560 w 487680"/>
                        <a:gd name="connsiteY8" fmla="*/ 121920 h 899160"/>
                        <a:gd name="connsiteX9" fmla="*/ 365760 w 487680"/>
                        <a:gd name="connsiteY9" fmla="*/ 0 h 899160"/>
                        <a:gd name="connsiteX10" fmla="*/ 441960 w 487680"/>
                        <a:gd name="connsiteY10" fmla="*/ 15240 h 899160"/>
                        <a:gd name="connsiteX11" fmla="*/ 487680 w 487680"/>
                        <a:gd name="connsiteY11" fmla="*/ 106680 h 899160"/>
                        <a:gd name="connsiteX12" fmla="*/ 472440 w 487680"/>
                        <a:gd name="connsiteY12" fmla="*/ 381000 h 899160"/>
                        <a:gd name="connsiteX13" fmla="*/ 411480 w 487680"/>
                        <a:gd name="connsiteY13" fmla="*/ 594360 h 899160"/>
                        <a:gd name="connsiteX14" fmla="*/ 381000 w 487680"/>
                        <a:gd name="connsiteY14" fmla="*/ 640080 h 899160"/>
                        <a:gd name="connsiteX15" fmla="*/ 350520 w 487680"/>
                        <a:gd name="connsiteY15" fmla="*/ 731520 h 899160"/>
                        <a:gd name="connsiteX16" fmla="*/ 274320 w 487680"/>
                        <a:gd name="connsiteY16" fmla="*/ 868680 h 899160"/>
                        <a:gd name="connsiteX17" fmla="*/ 228600 w 487680"/>
                        <a:gd name="connsiteY17" fmla="*/ 899160 h 899160"/>
                        <a:gd name="connsiteX18" fmla="*/ 76200 w 487680"/>
                        <a:gd name="connsiteY18" fmla="*/ 868680 h 899160"/>
                        <a:gd name="connsiteX19" fmla="*/ 76200 w 487680"/>
                        <a:gd name="connsiteY19" fmla="*/ 868680 h 89916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</a:cxnLst>
                      <a:rect l="l" t="t" r="r" b="b"/>
                      <a:pathLst>
                        <a:path w="487680" h="899160">
                          <a:moveTo>
                            <a:pt x="0" y="640080"/>
                          </a:moveTo>
                          <a:lnTo>
                            <a:pt x="0" y="640080"/>
                          </a:lnTo>
                          <a:lnTo>
                            <a:pt x="106680" y="487680"/>
                          </a:lnTo>
                          <a:cubicBezTo>
                            <a:pt x="117106" y="472621"/>
                            <a:pt x="131368" y="459336"/>
                            <a:pt x="137160" y="441960"/>
                          </a:cubicBezTo>
                          <a:cubicBezTo>
                            <a:pt x="175466" y="327042"/>
                            <a:pt x="123794" y="468693"/>
                            <a:pt x="182880" y="350520"/>
                          </a:cubicBezTo>
                          <a:cubicBezTo>
                            <a:pt x="190064" y="336152"/>
                            <a:pt x="190936" y="319168"/>
                            <a:pt x="198120" y="304800"/>
                          </a:cubicBezTo>
                          <a:cubicBezTo>
                            <a:pt x="206311" y="288417"/>
                            <a:pt x="221161" y="275818"/>
                            <a:pt x="228600" y="259080"/>
                          </a:cubicBezTo>
                          <a:cubicBezTo>
                            <a:pt x="241649" y="229720"/>
                            <a:pt x="241258" y="194373"/>
                            <a:pt x="259080" y="167640"/>
                          </a:cubicBezTo>
                          <a:cubicBezTo>
                            <a:pt x="269240" y="152400"/>
                            <a:pt x="282121" y="138658"/>
                            <a:pt x="289560" y="121920"/>
                          </a:cubicBezTo>
                          <a:cubicBezTo>
                            <a:pt x="343014" y="1649"/>
                            <a:pt x="283512" y="54832"/>
                            <a:pt x="365760" y="0"/>
                          </a:cubicBezTo>
                          <a:cubicBezTo>
                            <a:pt x="391160" y="5080"/>
                            <a:pt x="419470" y="2389"/>
                            <a:pt x="441960" y="15240"/>
                          </a:cubicBezTo>
                          <a:cubicBezTo>
                            <a:pt x="466290" y="29143"/>
                            <a:pt x="479857" y="83212"/>
                            <a:pt x="487680" y="106680"/>
                          </a:cubicBezTo>
                          <a:cubicBezTo>
                            <a:pt x="482600" y="198120"/>
                            <a:pt x="482937" y="290023"/>
                            <a:pt x="472440" y="381000"/>
                          </a:cubicBezTo>
                          <a:cubicBezTo>
                            <a:pt x="471022" y="393288"/>
                            <a:pt x="426941" y="571169"/>
                            <a:pt x="411480" y="594360"/>
                          </a:cubicBezTo>
                          <a:cubicBezTo>
                            <a:pt x="401320" y="609600"/>
                            <a:pt x="388439" y="623342"/>
                            <a:pt x="381000" y="640080"/>
                          </a:cubicBezTo>
                          <a:cubicBezTo>
                            <a:pt x="367951" y="669440"/>
                            <a:pt x="360680" y="701040"/>
                            <a:pt x="350520" y="731520"/>
                          </a:cubicBezTo>
                          <a:cubicBezTo>
                            <a:pt x="334639" y="779164"/>
                            <a:pt x="319237" y="838735"/>
                            <a:pt x="274320" y="868680"/>
                          </a:cubicBezTo>
                          <a:lnTo>
                            <a:pt x="228600" y="899160"/>
                          </a:lnTo>
                          <a:cubicBezTo>
                            <a:pt x="84300" y="883127"/>
                            <a:pt x="123968" y="916448"/>
                            <a:pt x="76200" y="868680"/>
                          </a:cubicBezTo>
                          <a:lnTo>
                            <a:pt x="76200" y="868680"/>
                          </a:lnTo>
                        </a:path>
                      </a:pathLst>
                    </a:cu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endParaRPr lang="ja-JP" altLang="en-US"/>
                    </a:p>
                  </p:txBody>
                </p:sp>
              </p:grpSp>
              <p:sp>
                <p:nvSpPr>
                  <p:cNvPr id="290" name="正方形/長方形 289"/>
                  <p:cNvSpPr/>
                  <p:nvPr/>
                </p:nvSpPr>
                <p:spPr>
                  <a:xfrm>
                    <a:off x="8640698" y="2317440"/>
                    <a:ext cx="107956" cy="10790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ja-JP" altLang="en-US"/>
                  </a:p>
                </p:txBody>
              </p:sp>
              <p:sp>
                <p:nvSpPr>
                  <p:cNvPr id="291" name="二等辺三角形 290"/>
                  <p:cNvSpPr/>
                  <p:nvPr/>
                </p:nvSpPr>
                <p:spPr>
                  <a:xfrm>
                    <a:off x="8034965" y="2461761"/>
                    <a:ext cx="107957" cy="107901"/>
                  </a:xfrm>
                  <a:prstGeom prst="triangle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ja-JP" altLang="en-US"/>
                  </a:p>
                </p:txBody>
              </p:sp>
              <p:sp>
                <p:nvSpPr>
                  <p:cNvPr id="292" name="テキスト ボックス 3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686964" y="1957379"/>
                    <a:ext cx="444500" cy="40005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kumimoji="1"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ja-JP" altLang="en-US" sz="2000">
                        <a:solidFill>
                          <a:schemeClr val="bg1"/>
                        </a:solidFill>
                      </a:rPr>
                      <a:t>*</a:t>
                    </a:r>
                  </a:p>
                </p:txBody>
              </p:sp>
              <p:sp>
                <p:nvSpPr>
                  <p:cNvPr id="293" name="テキスト ボックス 3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40399" y="2006827"/>
                    <a:ext cx="407987" cy="40005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kumimoji="1"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ja-JP" altLang="en-US" sz="2000">
                        <a:solidFill>
                          <a:schemeClr val="bg1"/>
                        </a:solidFill>
                      </a:rPr>
                      <a:t>*</a:t>
                    </a:r>
                  </a:p>
                </p:txBody>
              </p:sp>
              <p:sp>
                <p:nvSpPr>
                  <p:cNvPr id="294" name="テキスト ボックス 3892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122165" y="588489"/>
                    <a:ext cx="711200" cy="3134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6350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kumimoji="1"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algn="just"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ja-JP" sz="16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A</a:t>
                    </a:r>
                    <a:r>
                      <a:rPr lang="en-US" altLang="ja-JP" sz="1600" baseline="300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2</a:t>
                    </a:r>
                    <a:r>
                      <a:rPr lang="en-US" altLang="ja-JP" sz="16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a </a:t>
                    </a:r>
                    <a:endParaRPr lang="ja-JP" altLang="ja-JP" sz="1600"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5" name="テキスト ボックス 3892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830626" y="2286662"/>
                    <a:ext cx="711200" cy="4318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6350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kumimoji="1"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 kumimoji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algn="just"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ja-JP" sz="16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A</a:t>
                    </a:r>
                    <a:r>
                      <a:rPr lang="en-US" altLang="ja-JP" sz="1600" baseline="300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2</a:t>
                    </a:r>
                    <a:r>
                      <a:rPr lang="en-US" altLang="ja-JP" sz="16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rPr>
                      <a:t>b </a:t>
                    </a:r>
                    <a:endParaRPr lang="ja-JP" altLang="ja-JP" sz="1600" dirty="0"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296" name="直線コネクタ 5142"/>
                  <p:cNvCxnSpPr/>
                  <p:nvPr/>
                </p:nvCxnSpPr>
                <p:spPr>
                  <a:xfrm flipV="1">
                    <a:off x="7386118" y="2228799"/>
                    <a:ext cx="296880" cy="2856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cxnSp>
            <p:nvCxnSpPr>
              <p:cNvPr id="286" name="直線コネクタ 285"/>
              <p:cNvCxnSpPr>
                <a:endCxn id="294" idx="2"/>
              </p:cNvCxnSpPr>
              <p:nvPr/>
            </p:nvCxnSpPr>
            <p:spPr>
              <a:xfrm flipH="1" flipV="1">
                <a:off x="6105394" y="902034"/>
                <a:ext cx="373084" cy="117897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2" name="テキスト ボックス 96"/>
            <p:cNvSpPr txBox="1">
              <a:spLocks noChangeArrowheads="1"/>
            </p:cNvSpPr>
            <p:nvPr/>
          </p:nvSpPr>
          <p:spPr bwMode="auto">
            <a:xfrm>
              <a:off x="5968239" y="240313"/>
              <a:ext cx="1864480" cy="3465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. </a:t>
              </a:r>
              <a:r>
                <a:rPr lang="en-US" altLang="ja-JP" sz="1200" b="1" u="sng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+A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ja-JP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sc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ype</a:t>
              </a:r>
              <a:endParaRPr lang="ja-JP" alt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テキスト ボックス 81"/>
            <p:cNvSpPr txBox="1">
              <a:spLocks noChangeArrowheads="1"/>
            </p:cNvSpPr>
            <p:nvPr/>
          </p:nvSpPr>
          <p:spPr bwMode="auto">
            <a:xfrm>
              <a:off x="5512382" y="2949164"/>
              <a:ext cx="2702170" cy="577545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+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from A. </a:t>
              </a:r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sc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endPara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8.5%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コンテンツ プレースホルダー 7"/>
            <p:cNvSpPr txBox="1">
              <a:spLocks/>
            </p:cNvSpPr>
            <p:nvPr/>
          </p:nvSpPr>
          <p:spPr bwMode="auto">
            <a:xfrm>
              <a:off x="5352282" y="84135"/>
              <a:ext cx="496887" cy="415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noAutofit/>
            </a:bodyPr>
            <a:lstStyle>
              <a:lvl1pPr marL="228600" indent="-228600" algn="l" rtl="0" fontAlgn="base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ctr" eaLnBrk="1" fontAlgn="auto" hangingPunct="1">
                <a:spcAft>
                  <a:spcPts val="0"/>
                </a:spcAft>
                <a:buFont typeface="Arial" panose="020B0604020202020204" pitchFamily="34" charset="0"/>
                <a:buNone/>
                <a:defRPr/>
              </a:pPr>
              <a:r>
                <a:rPr lang="en-US" altLang="ja-JP" sz="2600" dirty="0"/>
                <a:t>b</a:t>
              </a:r>
              <a:endParaRPr lang="ja-JP" altLang="en-US" sz="2600" dirty="0"/>
            </a:p>
          </p:txBody>
        </p:sp>
      </p:grpSp>
      <p:grpSp>
        <p:nvGrpSpPr>
          <p:cNvPr id="299" name="グループ化 16"/>
          <p:cNvGrpSpPr>
            <a:grpSpLocks noChangeAspect="1"/>
          </p:cNvGrpSpPr>
          <p:nvPr/>
        </p:nvGrpSpPr>
        <p:grpSpPr bwMode="auto">
          <a:xfrm>
            <a:off x="1385535" y="97473"/>
            <a:ext cx="2238192" cy="2747025"/>
            <a:chOff x="2407692" y="48153"/>
            <a:chExt cx="2969349" cy="3644895"/>
          </a:xfrm>
        </p:grpSpPr>
        <p:grpSp>
          <p:nvGrpSpPr>
            <p:cNvPr id="300" name="グループ化 3"/>
            <p:cNvGrpSpPr>
              <a:grpSpLocks/>
            </p:cNvGrpSpPr>
            <p:nvPr/>
          </p:nvGrpSpPr>
          <p:grpSpPr bwMode="auto">
            <a:xfrm>
              <a:off x="2511425" y="514762"/>
              <a:ext cx="2865616" cy="2550030"/>
              <a:chOff x="3882888" y="514762"/>
              <a:chExt cx="2865615" cy="2550030"/>
            </a:xfrm>
          </p:grpSpPr>
          <p:pic>
            <p:nvPicPr>
              <p:cNvPr id="304" name="図 1"/>
              <p:cNvPicPr>
                <a:picLocks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617" b="6139"/>
              <a:stretch/>
            </p:blipFill>
            <p:spPr bwMode="auto">
              <a:xfrm>
                <a:off x="3882888" y="579840"/>
                <a:ext cx="2865615" cy="24849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05" name="正方形/長方形 304"/>
              <p:cNvSpPr/>
              <p:nvPr/>
            </p:nvSpPr>
            <p:spPr>
              <a:xfrm>
                <a:off x="5684700" y="2190581"/>
                <a:ext cx="107950" cy="10796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306" name="二等辺三角形 305"/>
              <p:cNvSpPr/>
              <p:nvPr/>
            </p:nvSpPr>
            <p:spPr>
              <a:xfrm>
                <a:off x="5340801" y="2508113"/>
                <a:ext cx="107950" cy="107965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307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5051552" y="1416235"/>
                <a:ext cx="365124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308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5055269" y="2096813"/>
                <a:ext cx="331932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309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4303073" y="514762"/>
                <a:ext cx="711201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2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0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3956050" y="2036763"/>
                <a:ext cx="711200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2</a:t>
                </a:r>
                <a:r>
                  <a:rPr lang="en-US" altLang="ja-JP" sz="160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b </a:t>
                </a:r>
                <a:endParaRPr lang="ja-JP" altLang="ja-JP" sz="160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11" name="直線コネクタ 5134"/>
              <p:cNvCxnSpPr/>
              <p:nvPr/>
            </p:nvCxnSpPr>
            <p:spPr>
              <a:xfrm>
                <a:off x="4592772" y="868286"/>
                <a:ext cx="623887" cy="69383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2" name="直線コネクタ 5137"/>
              <p:cNvCxnSpPr/>
              <p:nvPr/>
            </p:nvCxnSpPr>
            <p:spPr>
              <a:xfrm>
                <a:off x="4516301" y="2252503"/>
                <a:ext cx="682625" cy="1428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1" name="テキスト ボックス 77"/>
            <p:cNvSpPr txBox="1">
              <a:spLocks noChangeArrowheads="1"/>
            </p:cNvSpPr>
            <p:nvPr/>
          </p:nvSpPr>
          <p:spPr bwMode="auto">
            <a:xfrm>
              <a:off x="2510241" y="3080487"/>
              <a:ext cx="2865614" cy="612561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from A. rec, 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from </a:t>
              </a:r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.asc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6.4%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テキスト ボックス 3"/>
            <p:cNvSpPr txBox="1">
              <a:spLocks noChangeArrowheads="1"/>
            </p:cNvSpPr>
            <p:nvPr/>
          </p:nvSpPr>
          <p:spPr bwMode="auto">
            <a:xfrm>
              <a:off x="2938282" y="202547"/>
              <a:ext cx="2229836" cy="3675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. </a:t>
              </a:r>
              <a:r>
                <a:rPr lang="en-US" altLang="ja-JP" sz="1200" b="1" u="sng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+A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ja-JP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sc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ype</a:t>
              </a:r>
              <a:endParaRPr lang="ja-JP" alt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コンテンツ プレースホルダー 7"/>
            <p:cNvSpPr txBox="1">
              <a:spLocks/>
            </p:cNvSpPr>
            <p:nvPr/>
          </p:nvSpPr>
          <p:spPr bwMode="auto">
            <a:xfrm>
              <a:off x="2407692" y="48153"/>
              <a:ext cx="496888" cy="4159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noAutofit/>
            </a:bodyPr>
            <a:lstStyle>
              <a:lvl1pPr marL="228600" indent="-228600" algn="l" rtl="0" fontAlgn="base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ctr" eaLnBrk="1" fontAlgn="auto" hangingPunct="1">
                <a:spcAft>
                  <a:spcPts val="0"/>
                </a:spcAft>
                <a:buFont typeface="Arial" panose="020B0604020202020204" pitchFamily="34" charset="0"/>
                <a:buNone/>
                <a:defRPr/>
              </a:pPr>
              <a:r>
                <a:rPr lang="en-US" altLang="ja-JP" sz="2600" dirty="0" smtClean="0"/>
                <a:t>a</a:t>
              </a:r>
              <a:endParaRPr lang="ja-JP" altLang="en-US" sz="2600" dirty="0"/>
            </a:p>
          </p:txBody>
        </p:sp>
      </p:grpSp>
      <p:sp>
        <p:nvSpPr>
          <p:cNvPr id="313" name="タイトル 1"/>
          <p:cNvSpPr>
            <a:spLocks noGrp="1"/>
          </p:cNvSpPr>
          <p:nvPr>
            <p:ph type="title"/>
          </p:nvPr>
        </p:nvSpPr>
        <p:spPr>
          <a:xfrm>
            <a:off x="-1080" y="1467"/>
            <a:ext cx="1309598" cy="434144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ja-JP" sz="20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-Figure 2</a:t>
            </a:r>
            <a:endParaRPr lang="ja-JP" altLang="en-US" sz="2000" u="sng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35226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11"/>
          <p:cNvGrpSpPr>
            <a:grpSpLocks noChangeAspect="1"/>
          </p:cNvGrpSpPr>
          <p:nvPr/>
        </p:nvGrpSpPr>
        <p:grpSpPr bwMode="auto">
          <a:xfrm>
            <a:off x="1336837" y="5483104"/>
            <a:ext cx="2297728" cy="2730783"/>
            <a:chOff x="5512330" y="3584311"/>
            <a:chExt cx="3070698" cy="3613393"/>
          </a:xfrm>
        </p:grpSpPr>
        <p:grpSp>
          <p:nvGrpSpPr>
            <p:cNvPr id="5" name="グループ化 7"/>
            <p:cNvGrpSpPr>
              <a:grpSpLocks/>
            </p:cNvGrpSpPr>
            <p:nvPr/>
          </p:nvGrpSpPr>
          <p:grpSpPr bwMode="auto">
            <a:xfrm>
              <a:off x="5657957" y="4080223"/>
              <a:ext cx="2887482" cy="2477050"/>
              <a:chOff x="5648049" y="3875301"/>
              <a:chExt cx="2887866" cy="2477713"/>
            </a:xfrm>
          </p:grpSpPr>
          <p:pic>
            <p:nvPicPr>
              <p:cNvPr id="9" name="Picture 3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000" t="25468" r="36002" b="30850"/>
              <a:stretch/>
            </p:blipFill>
            <p:spPr bwMode="auto">
              <a:xfrm>
                <a:off x="5648049" y="3875301"/>
                <a:ext cx="2887866" cy="2477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" name="正方形/長方形 9"/>
              <p:cNvSpPr/>
              <p:nvPr/>
            </p:nvSpPr>
            <p:spPr>
              <a:xfrm>
                <a:off x="7726214" y="5249105"/>
                <a:ext cx="90494" cy="905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11" name="二等辺三角形 10"/>
              <p:cNvSpPr/>
              <p:nvPr/>
            </p:nvSpPr>
            <p:spPr>
              <a:xfrm>
                <a:off x="6965745" y="5966917"/>
                <a:ext cx="90495" cy="9052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12" name="円/楕円 11"/>
              <p:cNvSpPr>
                <a:spLocks/>
              </p:cNvSpPr>
              <p:nvPr/>
            </p:nvSpPr>
            <p:spPr>
              <a:xfrm>
                <a:off x="7764316" y="5727116"/>
                <a:ext cx="90494" cy="90521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sp>
            <p:nvSpPr>
              <p:cNvPr id="13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7381781" y="5419912"/>
                <a:ext cx="330200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14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6621432" y="5437188"/>
                <a:ext cx="365125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15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5869916" y="4482102"/>
                <a:ext cx="711200" cy="4318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b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5696079" y="5703710"/>
                <a:ext cx="711200" cy="4318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7" name="直線コネクタ 16"/>
              <p:cNvCxnSpPr/>
              <p:nvPr/>
            </p:nvCxnSpPr>
            <p:spPr>
              <a:xfrm flipH="1">
                <a:off x="6276645" y="5658391"/>
                <a:ext cx="485809" cy="21493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線コネクタ 17"/>
              <p:cNvCxnSpPr/>
              <p:nvPr/>
            </p:nvCxnSpPr>
            <p:spPr>
              <a:xfrm>
                <a:off x="6398814" y="4845075"/>
                <a:ext cx="1147846" cy="73051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" name="コンテンツ プレースホルダー 7"/>
            <p:cNvSpPr txBox="1">
              <a:spLocks/>
            </p:cNvSpPr>
            <p:nvPr/>
          </p:nvSpPr>
          <p:spPr bwMode="auto">
            <a:xfrm>
              <a:off x="5512330" y="3584311"/>
              <a:ext cx="496857" cy="4159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  <p:txBody>
            <a:bodyPr>
              <a:noAutofit/>
            </a:bodyPr>
            <a:lstStyle>
              <a:lvl1pPr marL="228600" indent="-228600" algn="l" rtl="0" fontAlgn="base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ctr" eaLnBrk="1" fontAlgn="auto" hangingPunct="1">
                <a:spcAft>
                  <a:spcPts val="0"/>
                </a:spcAft>
                <a:buFont typeface="Arial" panose="020B0604020202020204" pitchFamily="34" charset="0"/>
                <a:buNone/>
                <a:defRPr/>
              </a:pPr>
              <a:r>
                <a:rPr lang="en-US" altLang="ja-JP" sz="2600" dirty="0"/>
                <a:t>e</a:t>
              </a:r>
              <a:endParaRPr lang="ja-JP" altLang="en-US" sz="2600" dirty="0"/>
            </a:p>
          </p:txBody>
        </p:sp>
        <p:sp>
          <p:nvSpPr>
            <p:cNvPr id="7" name="テキスト ボックス 93"/>
            <p:cNvSpPr txBox="1">
              <a:spLocks noChangeArrowheads="1"/>
            </p:cNvSpPr>
            <p:nvPr/>
          </p:nvSpPr>
          <p:spPr bwMode="auto">
            <a:xfrm>
              <a:off x="5654454" y="6586824"/>
              <a:ext cx="2886637" cy="61088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from Tr. </a:t>
              </a:r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f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from </a:t>
              </a:r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A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sc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1.9%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95"/>
            <p:cNvSpPr txBox="1">
              <a:spLocks noChangeArrowheads="1"/>
            </p:cNvSpPr>
            <p:nvPr/>
          </p:nvSpPr>
          <p:spPr bwMode="auto">
            <a:xfrm>
              <a:off x="5898244" y="3762640"/>
              <a:ext cx="2684784" cy="366527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. </a:t>
              </a:r>
              <a:r>
                <a:rPr lang="en-US" altLang="ja-JP" sz="1200" b="1" u="sng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+Tr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ja-JP" sz="1200" b="1" u="sng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f+A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ja-JP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sc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ype</a:t>
              </a:r>
              <a:endParaRPr lang="ja-JP" alt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" name="グループ化 15"/>
          <p:cNvGrpSpPr>
            <a:grpSpLocks noChangeAspect="1"/>
          </p:cNvGrpSpPr>
          <p:nvPr/>
        </p:nvGrpSpPr>
        <p:grpSpPr bwMode="auto">
          <a:xfrm>
            <a:off x="3791353" y="45369"/>
            <a:ext cx="2244828" cy="2725393"/>
            <a:chOff x="5595074" y="140024"/>
            <a:chExt cx="3039258" cy="3691384"/>
          </a:xfrm>
        </p:grpSpPr>
        <p:pic>
          <p:nvPicPr>
            <p:cNvPr id="20" name="図 14"/>
            <p:cNvPicPr>
              <a:picLocks/>
            </p:cNvPicPr>
            <p:nvPr/>
          </p:nvPicPr>
          <p:blipFill rotWithShape="1">
            <a:blip r:embed="rId3">
              <a:clrChange>
                <a:clrFrom>
                  <a:srgbClr val="FEFEFE"/>
                </a:clrFrom>
                <a:clrTo>
                  <a:srgbClr val="FEFEFE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938"/>
            <a:stretch/>
          </p:blipFill>
          <p:spPr bwMode="auto">
            <a:xfrm>
              <a:off x="5673677" y="646023"/>
              <a:ext cx="2924409" cy="25355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1" name="グループ化 15"/>
            <p:cNvGrpSpPr>
              <a:grpSpLocks/>
            </p:cNvGrpSpPr>
            <p:nvPr/>
          </p:nvGrpSpPr>
          <p:grpSpPr bwMode="auto">
            <a:xfrm>
              <a:off x="5595074" y="140024"/>
              <a:ext cx="3039258" cy="3691384"/>
              <a:chOff x="5595168" y="140025"/>
              <a:chExt cx="3039148" cy="3692128"/>
            </a:xfrm>
          </p:grpSpPr>
          <p:sp>
            <p:nvSpPr>
              <p:cNvPr id="22" name="コンテンツ プレースホルダー 7"/>
              <p:cNvSpPr txBox="1">
                <a:spLocks/>
              </p:cNvSpPr>
              <p:nvPr/>
            </p:nvSpPr>
            <p:spPr bwMode="auto">
              <a:xfrm>
                <a:off x="5595168" y="140025"/>
                <a:ext cx="496784" cy="4161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noAutofit/>
              </a:bodyPr>
              <a:lstStyle>
                <a:lvl1pPr marL="228600" indent="-228600" algn="l" rtl="0" fontAlgn="base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eaLnBrk="1" fontAlgn="auto" hangingPunct="1">
                  <a:spcAft>
                    <a:spcPts val="0"/>
                  </a:spcAft>
                  <a:buFont typeface="Arial" panose="020B0604020202020204" pitchFamily="34" charset="0"/>
                  <a:buNone/>
                  <a:defRPr/>
                </a:pPr>
                <a:r>
                  <a:rPr lang="en-US" altLang="ja-JP" sz="2600" dirty="0" smtClean="0"/>
                  <a:t>b</a:t>
                </a:r>
                <a:endParaRPr lang="ja-JP" altLang="en-US" sz="2600" dirty="0"/>
              </a:p>
            </p:txBody>
          </p:sp>
          <p:sp>
            <p:nvSpPr>
              <p:cNvPr id="23" name="正方形/長方形 22"/>
              <p:cNvSpPr/>
              <p:nvPr/>
            </p:nvSpPr>
            <p:spPr>
              <a:xfrm>
                <a:off x="6913384" y="1732666"/>
                <a:ext cx="88882" cy="9052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24" name="二等辺三角形 23"/>
              <p:cNvSpPr/>
              <p:nvPr/>
            </p:nvSpPr>
            <p:spPr>
              <a:xfrm>
                <a:off x="7002266" y="2715759"/>
                <a:ext cx="88882" cy="90528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25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7325781" y="1875716"/>
                <a:ext cx="365125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26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7136861" y="2469799"/>
                <a:ext cx="365125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27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7879625" y="631890"/>
                <a:ext cx="682338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b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8" name="直線コネクタ 27"/>
              <p:cNvCxnSpPr/>
              <p:nvPr/>
            </p:nvCxnSpPr>
            <p:spPr>
              <a:xfrm flipH="1">
                <a:off x="7571028" y="1037046"/>
                <a:ext cx="486406" cy="99612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7903239" y="1077340"/>
                <a:ext cx="731077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0" name="直線コネクタ 29"/>
              <p:cNvCxnSpPr/>
              <p:nvPr/>
            </p:nvCxnSpPr>
            <p:spPr>
              <a:xfrm flipV="1">
                <a:off x="7383187" y="1434086"/>
                <a:ext cx="884056" cy="118797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テキスト ボックス 90"/>
              <p:cNvSpPr txBox="1">
                <a:spLocks noChangeArrowheads="1"/>
              </p:cNvSpPr>
              <p:nvPr/>
            </p:nvSpPr>
            <p:spPr bwMode="auto">
              <a:xfrm>
                <a:off x="5675213" y="3206729"/>
                <a:ext cx="2924304" cy="625424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 from Tr. sup, A</a:t>
                </a:r>
                <a:r>
                  <a:rPr lang="en-US" altLang="ja-JP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 from </a:t>
                </a:r>
                <a:r>
                  <a:rPr lang="en-US" altLang="ja-JP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A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ja-JP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c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</a:t>
                </a:r>
                <a:r>
                  <a:rPr lang="en-US" altLang="ja-JP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.9%</a:t>
                </a:r>
                <a:endPara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テキスト ボックス 91"/>
              <p:cNvSpPr txBox="1">
                <a:spLocks noChangeArrowheads="1"/>
              </p:cNvSpPr>
              <p:nvPr/>
            </p:nvSpPr>
            <p:spPr bwMode="auto">
              <a:xfrm>
                <a:off x="6160969" y="321315"/>
                <a:ext cx="2033673" cy="375254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. </a:t>
                </a:r>
                <a:r>
                  <a:rPr lang="en-US" altLang="ja-JP" sz="1200" b="1" u="sng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+A</a:t>
                </a: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ja-JP" sz="1200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c</a:t>
                </a: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ype</a:t>
                </a:r>
                <a:endParaRPr lang="ja-JP" altLang="en-US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3" name="グループ化 2"/>
          <p:cNvGrpSpPr>
            <a:grpSpLocks noChangeAspect="1"/>
          </p:cNvGrpSpPr>
          <p:nvPr/>
        </p:nvGrpSpPr>
        <p:grpSpPr bwMode="auto">
          <a:xfrm>
            <a:off x="1373120" y="2767161"/>
            <a:ext cx="2264595" cy="2711489"/>
            <a:chOff x="8743947" y="85064"/>
            <a:chExt cx="2908298" cy="3483047"/>
          </a:xfrm>
        </p:grpSpPr>
        <p:pic>
          <p:nvPicPr>
            <p:cNvPr id="34" name="図 1"/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146" r="1928" b="7736"/>
            <a:stretch/>
          </p:blipFill>
          <p:spPr bwMode="auto">
            <a:xfrm>
              <a:off x="8767658" y="555935"/>
              <a:ext cx="2773970" cy="24046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35" name="グループ化 14"/>
            <p:cNvGrpSpPr>
              <a:grpSpLocks/>
            </p:cNvGrpSpPr>
            <p:nvPr/>
          </p:nvGrpSpPr>
          <p:grpSpPr bwMode="auto">
            <a:xfrm>
              <a:off x="8743947" y="85064"/>
              <a:ext cx="2908298" cy="3483047"/>
              <a:chOff x="8713335" y="85054"/>
              <a:chExt cx="2908753" cy="3483749"/>
            </a:xfrm>
          </p:grpSpPr>
          <p:grpSp>
            <p:nvGrpSpPr>
              <p:cNvPr id="36" name="グループ化 7"/>
              <p:cNvGrpSpPr>
                <a:grpSpLocks/>
              </p:cNvGrpSpPr>
              <p:nvPr/>
            </p:nvGrpSpPr>
            <p:grpSpPr bwMode="auto">
              <a:xfrm>
                <a:off x="8713335" y="1365797"/>
                <a:ext cx="2908753" cy="1885184"/>
                <a:chOff x="8713889" y="1366171"/>
                <a:chExt cx="2908906" cy="1885172"/>
              </a:xfrm>
            </p:grpSpPr>
            <p:sp>
              <p:nvSpPr>
                <p:cNvPr id="40" name="正方形/長方形 39"/>
                <p:cNvSpPr/>
                <p:nvPr/>
              </p:nvSpPr>
              <p:spPr bwMode="auto">
                <a:xfrm>
                  <a:off x="10989251" y="1934740"/>
                  <a:ext cx="87330" cy="9052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ja-JP" altLang="en-US"/>
                </a:p>
              </p:txBody>
            </p:sp>
            <p:sp>
              <p:nvSpPr>
                <p:cNvPr id="41" name="テキスト ボックス 33"/>
                <p:cNvSpPr txBox="1">
                  <a:spLocks noChangeArrowheads="1"/>
                </p:cNvSpPr>
                <p:nvPr/>
              </p:nvSpPr>
              <p:spPr bwMode="auto">
                <a:xfrm>
                  <a:off x="9826851" y="1859083"/>
                  <a:ext cx="358214" cy="400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ja-JP" altLang="en-US" sz="2000" dirty="0">
                      <a:solidFill>
                        <a:schemeClr val="bg1"/>
                      </a:solidFill>
                    </a:rPr>
                    <a:t>*</a:t>
                  </a:r>
                </a:p>
              </p:txBody>
            </p:sp>
            <p:sp>
              <p:nvSpPr>
                <p:cNvPr id="42" name="テキスト ボックス 33"/>
                <p:cNvSpPr txBox="1">
                  <a:spLocks noChangeArrowheads="1"/>
                </p:cNvSpPr>
                <p:nvPr/>
              </p:nvSpPr>
              <p:spPr bwMode="auto">
                <a:xfrm>
                  <a:off x="10020578" y="2092599"/>
                  <a:ext cx="358214" cy="400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ja-JP" altLang="en-US" sz="2000" dirty="0">
                      <a:solidFill>
                        <a:schemeClr val="bg1"/>
                      </a:solidFill>
                    </a:rPr>
                    <a:t>*</a:t>
                  </a:r>
                </a:p>
              </p:txBody>
            </p:sp>
            <p:sp>
              <p:nvSpPr>
                <p:cNvPr id="43" name="テキスト ボックス 38927"/>
                <p:cNvSpPr txBox="1">
                  <a:spLocks noChangeArrowheads="1"/>
                </p:cNvSpPr>
                <p:nvPr/>
              </p:nvSpPr>
              <p:spPr bwMode="auto">
                <a:xfrm>
                  <a:off x="8790749" y="1673737"/>
                  <a:ext cx="697738" cy="4318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6350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algn="just"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A</a:t>
                  </a:r>
                  <a:r>
                    <a:rPr lang="en-US" altLang="ja-JP" sz="1600" baseline="30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3</a:t>
                  </a:r>
                  <a:r>
                    <a:rPr lang="en-US" altLang="ja-JP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a </a:t>
                  </a:r>
                  <a:endParaRPr lang="ja-JP" altLang="ja-JP" sz="1600" dirty="0"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テキスト ボックス 38927"/>
                <p:cNvSpPr txBox="1">
                  <a:spLocks noChangeArrowheads="1"/>
                </p:cNvSpPr>
                <p:nvPr/>
              </p:nvSpPr>
              <p:spPr bwMode="auto">
                <a:xfrm>
                  <a:off x="8851210" y="2138462"/>
                  <a:ext cx="648749" cy="4318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6350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kumimoji="1"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algn="just"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A</a:t>
                  </a:r>
                  <a:r>
                    <a:rPr lang="en-US" altLang="ja-JP" sz="1600" baseline="30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3</a:t>
                  </a:r>
                  <a:r>
                    <a:rPr lang="en-US" altLang="ja-JP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Times New Roman" panose="02020603050405020304" pitchFamily="18" charset="0"/>
                    </a:rPr>
                    <a:t>b </a:t>
                  </a:r>
                  <a:endParaRPr lang="ja-JP" altLang="ja-JP" sz="1600" dirty="0"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5" name="直線コネクタ 44"/>
                <p:cNvCxnSpPr/>
                <p:nvPr/>
              </p:nvCxnSpPr>
              <p:spPr bwMode="auto">
                <a:xfrm>
                  <a:off x="9361724" y="1896624"/>
                  <a:ext cx="612903" cy="13340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直線コネクタ 45"/>
                <p:cNvCxnSpPr/>
                <p:nvPr/>
              </p:nvCxnSpPr>
              <p:spPr bwMode="auto">
                <a:xfrm flipV="1">
                  <a:off x="9423650" y="2290493"/>
                  <a:ext cx="727227" cy="71469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円/楕円 46"/>
                <p:cNvSpPr>
                  <a:spLocks/>
                </p:cNvSpPr>
                <p:nvPr/>
              </p:nvSpPr>
              <p:spPr>
                <a:xfrm>
                  <a:off x="10644691" y="2285729"/>
                  <a:ext cx="90507" cy="90526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ja-JP" altLang="en-US"/>
                </a:p>
              </p:txBody>
            </p:sp>
            <p:sp>
              <p:nvSpPr>
                <p:cNvPr id="48" name="フリーフォーム 47"/>
                <p:cNvSpPr/>
                <p:nvPr/>
              </p:nvSpPr>
              <p:spPr>
                <a:xfrm>
                  <a:off x="8713889" y="1366171"/>
                  <a:ext cx="201655" cy="276344"/>
                </a:xfrm>
                <a:custGeom>
                  <a:avLst/>
                  <a:gdLst>
                    <a:gd name="connsiteX0" fmla="*/ 0 w 201372"/>
                    <a:gd name="connsiteY0" fmla="*/ 0 h 275422"/>
                    <a:gd name="connsiteX1" fmla="*/ 0 w 201372"/>
                    <a:gd name="connsiteY1" fmla="*/ 0 h 275422"/>
                    <a:gd name="connsiteX2" fmla="*/ 99152 w 201372"/>
                    <a:gd name="connsiteY2" fmla="*/ 11017 h 275422"/>
                    <a:gd name="connsiteX3" fmla="*/ 154236 w 201372"/>
                    <a:gd name="connsiteY3" fmla="*/ 77118 h 275422"/>
                    <a:gd name="connsiteX4" fmla="*/ 187287 w 201372"/>
                    <a:gd name="connsiteY4" fmla="*/ 99152 h 275422"/>
                    <a:gd name="connsiteX5" fmla="*/ 187287 w 201372"/>
                    <a:gd name="connsiteY5" fmla="*/ 198304 h 275422"/>
                    <a:gd name="connsiteX6" fmla="*/ 154236 w 201372"/>
                    <a:gd name="connsiteY6" fmla="*/ 209321 h 275422"/>
                    <a:gd name="connsiteX7" fmla="*/ 121186 w 201372"/>
                    <a:gd name="connsiteY7" fmla="*/ 231355 h 275422"/>
                    <a:gd name="connsiteX8" fmla="*/ 99152 w 201372"/>
                    <a:gd name="connsiteY8" fmla="*/ 264405 h 275422"/>
                    <a:gd name="connsiteX9" fmla="*/ 66102 w 201372"/>
                    <a:gd name="connsiteY9" fmla="*/ 275422 h 275422"/>
                    <a:gd name="connsiteX10" fmla="*/ 11017 w 201372"/>
                    <a:gd name="connsiteY10" fmla="*/ 242371 h 275422"/>
                    <a:gd name="connsiteX11" fmla="*/ 11017 w 201372"/>
                    <a:gd name="connsiteY11" fmla="*/ 242371 h 275422"/>
                    <a:gd name="connsiteX12" fmla="*/ 0 w 201372"/>
                    <a:gd name="connsiteY12" fmla="*/ 88135 h 27542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</a:cxnLst>
                  <a:rect l="l" t="t" r="r" b="b"/>
                  <a:pathLst>
                    <a:path w="201372" h="275422">
                      <a:moveTo>
                        <a:pt x="0" y="0"/>
                      </a:moveTo>
                      <a:lnTo>
                        <a:pt x="0" y="0"/>
                      </a:lnTo>
                      <a:cubicBezTo>
                        <a:pt x="33051" y="3672"/>
                        <a:pt x="67604" y="501"/>
                        <a:pt x="99152" y="11017"/>
                      </a:cubicBezTo>
                      <a:cubicBezTo>
                        <a:pt x="126226" y="20042"/>
                        <a:pt x="136596" y="59478"/>
                        <a:pt x="154236" y="77118"/>
                      </a:cubicBezTo>
                      <a:cubicBezTo>
                        <a:pt x="163599" y="86481"/>
                        <a:pt x="176270" y="91807"/>
                        <a:pt x="187287" y="99152"/>
                      </a:cubicBezTo>
                      <a:cubicBezTo>
                        <a:pt x="199355" y="135356"/>
                        <a:pt x="211779" y="155444"/>
                        <a:pt x="187287" y="198304"/>
                      </a:cubicBezTo>
                      <a:cubicBezTo>
                        <a:pt x="181525" y="208387"/>
                        <a:pt x="165253" y="205649"/>
                        <a:pt x="154236" y="209321"/>
                      </a:cubicBezTo>
                      <a:cubicBezTo>
                        <a:pt x="143219" y="216666"/>
                        <a:pt x="130548" y="221993"/>
                        <a:pt x="121186" y="231355"/>
                      </a:cubicBezTo>
                      <a:cubicBezTo>
                        <a:pt x="111824" y="240717"/>
                        <a:pt x="109491" y="256134"/>
                        <a:pt x="99152" y="264405"/>
                      </a:cubicBezTo>
                      <a:cubicBezTo>
                        <a:pt x="90084" y="271659"/>
                        <a:pt x="77119" y="271750"/>
                        <a:pt x="66102" y="275422"/>
                      </a:cubicBezTo>
                      <a:cubicBezTo>
                        <a:pt x="14068" y="262413"/>
                        <a:pt x="28805" y="277948"/>
                        <a:pt x="11017" y="242371"/>
                      </a:cubicBezTo>
                      <a:lnTo>
                        <a:pt x="11017" y="242371"/>
                      </a:lnTo>
                      <a:lnTo>
                        <a:pt x="0" y="88135"/>
                      </a:lnTo>
                    </a:path>
                  </a:pathLst>
                </a:cu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ja-JP" altLang="en-US"/>
                </a:p>
              </p:txBody>
            </p:sp>
            <p:sp>
              <p:nvSpPr>
                <p:cNvPr id="49" name="フリーフォーム 48"/>
                <p:cNvSpPr/>
                <p:nvPr/>
              </p:nvSpPr>
              <p:spPr>
                <a:xfrm>
                  <a:off x="10994014" y="2832063"/>
                  <a:ext cx="628781" cy="419280"/>
                </a:xfrm>
                <a:custGeom>
                  <a:avLst/>
                  <a:gdLst>
                    <a:gd name="connsiteX0" fmla="*/ 0 w 627961"/>
                    <a:gd name="connsiteY0" fmla="*/ 121185 h 418641"/>
                    <a:gd name="connsiteX1" fmla="*/ 0 w 627961"/>
                    <a:gd name="connsiteY1" fmla="*/ 121185 h 418641"/>
                    <a:gd name="connsiteX2" fmla="*/ 330506 w 627961"/>
                    <a:gd name="connsiteY2" fmla="*/ 77118 h 418641"/>
                    <a:gd name="connsiteX3" fmla="*/ 429658 w 627961"/>
                    <a:gd name="connsiteY3" fmla="*/ 33051 h 418641"/>
                    <a:gd name="connsiteX4" fmla="*/ 495759 w 627961"/>
                    <a:gd name="connsiteY4" fmla="*/ 11017 h 418641"/>
                    <a:gd name="connsiteX5" fmla="*/ 528809 w 627961"/>
                    <a:gd name="connsiteY5" fmla="*/ 0 h 418641"/>
                    <a:gd name="connsiteX6" fmla="*/ 583894 w 627961"/>
                    <a:gd name="connsiteY6" fmla="*/ 11017 h 418641"/>
                    <a:gd name="connsiteX7" fmla="*/ 605927 w 627961"/>
                    <a:gd name="connsiteY7" fmla="*/ 44067 h 418641"/>
                    <a:gd name="connsiteX8" fmla="*/ 627961 w 627961"/>
                    <a:gd name="connsiteY8" fmla="*/ 132202 h 418641"/>
                    <a:gd name="connsiteX9" fmla="*/ 616944 w 627961"/>
                    <a:gd name="connsiteY9" fmla="*/ 341523 h 418641"/>
                    <a:gd name="connsiteX10" fmla="*/ 605927 w 627961"/>
                    <a:gd name="connsiteY10" fmla="*/ 374573 h 418641"/>
                    <a:gd name="connsiteX11" fmla="*/ 594911 w 627961"/>
                    <a:gd name="connsiteY11" fmla="*/ 418641 h 418641"/>
                    <a:gd name="connsiteX12" fmla="*/ 363556 w 627961"/>
                    <a:gd name="connsiteY12" fmla="*/ 396607 h 418641"/>
                    <a:gd name="connsiteX13" fmla="*/ 330506 w 627961"/>
                    <a:gd name="connsiteY13" fmla="*/ 385590 h 418641"/>
                    <a:gd name="connsiteX14" fmla="*/ 264405 w 627961"/>
                    <a:gd name="connsiteY14" fmla="*/ 374573 h 418641"/>
                    <a:gd name="connsiteX15" fmla="*/ 253388 w 627961"/>
                    <a:gd name="connsiteY15" fmla="*/ 341523 h 418641"/>
                    <a:gd name="connsiteX16" fmla="*/ 209320 w 627961"/>
                    <a:gd name="connsiteY16" fmla="*/ 275422 h 418641"/>
                    <a:gd name="connsiteX17" fmla="*/ 198303 w 627961"/>
                    <a:gd name="connsiteY17" fmla="*/ 275422 h 418641"/>
                    <a:gd name="connsiteX18" fmla="*/ 198303 w 627961"/>
                    <a:gd name="connsiteY18" fmla="*/ 275422 h 4186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</a:cxnLst>
                  <a:rect l="l" t="t" r="r" b="b"/>
                  <a:pathLst>
                    <a:path w="627961" h="418641">
                      <a:moveTo>
                        <a:pt x="0" y="121185"/>
                      </a:moveTo>
                      <a:lnTo>
                        <a:pt x="0" y="121185"/>
                      </a:lnTo>
                      <a:cubicBezTo>
                        <a:pt x="188317" y="50568"/>
                        <a:pt x="-6249" y="113199"/>
                        <a:pt x="330506" y="77118"/>
                      </a:cubicBezTo>
                      <a:cubicBezTo>
                        <a:pt x="416939" y="67857"/>
                        <a:pt x="372852" y="58298"/>
                        <a:pt x="429658" y="33051"/>
                      </a:cubicBezTo>
                      <a:cubicBezTo>
                        <a:pt x="450882" y="23618"/>
                        <a:pt x="473725" y="18362"/>
                        <a:pt x="495759" y="11017"/>
                      </a:cubicBezTo>
                      <a:lnTo>
                        <a:pt x="528809" y="0"/>
                      </a:lnTo>
                      <a:cubicBezTo>
                        <a:pt x="547171" y="3672"/>
                        <a:pt x="567636" y="1727"/>
                        <a:pt x="583894" y="11017"/>
                      </a:cubicBezTo>
                      <a:cubicBezTo>
                        <a:pt x="595390" y="17586"/>
                        <a:pt x="600006" y="32224"/>
                        <a:pt x="605927" y="44067"/>
                      </a:cubicBezTo>
                      <a:cubicBezTo>
                        <a:pt x="617219" y="66652"/>
                        <a:pt x="623771" y="111250"/>
                        <a:pt x="627961" y="132202"/>
                      </a:cubicBezTo>
                      <a:cubicBezTo>
                        <a:pt x="624289" y="201976"/>
                        <a:pt x="623270" y="271940"/>
                        <a:pt x="616944" y="341523"/>
                      </a:cubicBezTo>
                      <a:cubicBezTo>
                        <a:pt x="615893" y="353088"/>
                        <a:pt x="609117" y="363407"/>
                        <a:pt x="605927" y="374573"/>
                      </a:cubicBezTo>
                      <a:cubicBezTo>
                        <a:pt x="601767" y="389132"/>
                        <a:pt x="598583" y="403952"/>
                        <a:pt x="594911" y="418641"/>
                      </a:cubicBezTo>
                      <a:cubicBezTo>
                        <a:pt x="476720" y="389093"/>
                        <a:pt x="621521" y="422404"/>
                        <a:pt x="363556" y="396607"/>
                      </a:cubicBezTo>
                      <a:cubicBezTo>
                        <a:pt x="352001" y="395451"/>
                        <a:pt x="341842" y="388109"/>
                        <a:pt x="330506" y="385590"/>
                      </a:cubicBezTo>
                      <a:cubicBezTo>
                        <a:pt x="308700" y="380744"/>
                        <a:pt x="286439" y="378245"/>
                        <a:pt x="264405" y="374573"/>
                      </a:cubicBezTo>
                      <a:cubicBezTo>
                        <a:pt x="260733" y="363556"/>
                        <a:pt x="256578" y="352689"/>
                        <a:pt x="253388" y="341523"/>
                      </a:cubicBezTo>
                      <a:cubicBezTo>
                        <a:pt x="239688" y="293574"/>
                        <a:pt x="254507" y="298015"/>
                        <a:pt x="209320" y="275422"/>
                      </a:cubicBezTo>
                      <a:cubicBezTo>
                        <a:pt x="206035" y="273780"/>
                        <a:pt x="201975" y="275422"/>
                        <a:pt x="198303" y="275422"/>
                      </a:cubicBezTo>
                      <a:lnTo>
                        <a:pt x="198303" y="275422"/>
                      </a:lnTo>
                    </a:path>
                  </a:pathLst>
                </a:cu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ja-JP" altLang="en-US"/>
                </a:p>
              </p:txBody>
            </p:sp>
          </p:grpSp>
          <p:sp>
            <p:nvSpPr>
              <p:cNvPr id="37" name="コンテンツ プレースホルダー 7"/>
              <p:cNvSpPr txBox="1">
                <a:spLocks/>
              </p:cNvSpPr>
              <p:nvPr/>
            </p:nvSpPr>
            <p:spPr bwMode="auto">
              <a:xfrm>
                <a:off x="8764572" y="85054"/>
                <a:ext cx="314004" cy="4135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noAutofit/>
              </a:bodyPr>
              <a:lstStyle>
                <a:lvl1pPr marL="228600" indent="-228600" algn="l" rtl="0" fontAlgn="base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eaLnBrk="1" fontAlgn="auto" hangingPunct="1">
                  <a:spcAft>
                    <a:spcPts val="0"/>
                  </a:spcAft>
                  <a:buFont typeface="Arial" panose="020B0604020202020204" pitchFamily="34" charset="0"/>
                  <a:buNone/>
                  <a:defRPr/>
                </a:pPr>
                <a:r>
                  <a:rPr lang="en-US" altLang="ja-JP" sz="2600" dirty="0" smtClean="0"/>
                  <a:t>c</a:t>
                </a:r>
                <a:endParaRPr lang="ja-JP" altLang="en-US" sz="2600" dirty="0"/>
              </a:p>
            </p:txBody>
          </p:sp>
          <p:sp>
            <p:nvSpPr>
              <p:cNvPr id="38" name="テキスト ボックス 91"/>
              <p:cNvSpPr txBox="1">
                <a:spLocks noChangeArrowheads="1"/>
              </p:cNvSpPr>
              <p:nvPr/>
            </p:nvSpPr>
            <p:spPr bwMode="auto">
              <a:xfrm>
                <a:off x="8726248" y="2975651"/>
                <a:ext cx="2774405" cy="59315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+A</a:t>
                </a:r>
                <a:r>
                  <a:rPr lang="en-US" altLang="ja-JP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 from Tr. </a:t>
                </a:r>
                <a:r>
                  <a:rPr lang="en-US" altLang="ja-JP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f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</a:t>
                </a:r>
                <a:endPara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.6%</a:t>
                </a:r>
                <a:endPara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テキスト ボックス 93"/>
              <p:cNvSpPr txBox="1">
                <a:spLocks noChangeArrowheads="1"/>
              </p:cNvSpPr>
              <p:nvPr/>
            </p:nvSpPr>
            <p:spPr bwMode="auto">
              <a:xfrm>
                <a:off x="9287715" y="240675"/>
                <a:ext cx="1898297" cy="355891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. </a:t>
                </a:r>
                <a:r>
                  <a:rPr lang="en-US" altLang="ja-JP" sz="1200" b="1" u="sng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+Tr</a:t>
                </a: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ja-JP" sz="1200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f</a:t>
                </a: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ype</a:t>
                </a:r>
                <a:endParaRPr lang="ja-JP" altLang="en-US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50" name="グループ化 7"/>
          <p:cNvGrpSpPr>
            <a:grpSpLocks noChangeAspect="1"/>
          </p:cNvGrpSpPr>
          <p:nvPr/>
        </p:nvGrpSpPr>
        <p:grpSpPr bwMode="auto">
          <a:xfrm>
            <a:off x="3771797" y="2798037"/>
            <a:ext cx="2307163" cy="2688040"/>
            <a:chOff x="2403285" y="3693415"/>
            <a:chExt cx="3030278" cy="3529597"/>
          </a:xfrm>
        </p:grpSpPr>
        <p:pic>
          <p:nvPicPr>
            <p:cNvPr id="51" name="図 2"/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906" r="2103" b="3846"/>
            <a:stretch/>
          </p:blipFill>
          <p:spPr bwMode="auto">
            <a:xfrm>
              <a:off x="2501527" y="4124245"/>
              <a:ext cx="2836988" cy="2458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52" name="グループ化 10"/>
            <p:cNvGrpSpPr>
              <a:grpSpLocks/>
            </p:cNvGrpSpPr>
            <p:nvPr/>
          </p:nvGrpSpPr>
          <p:grpSpPr bwMode="auto">
            <a:xfrm>
              <a:off x="2403285" y="3693415"/>
              <a:ext cx="3030278" cy="3529597"/>
              <a:chOff x="2473734" y="3723585"/>
              <a:chExt cx="3029622" cy="3529748"/>
            </a:xfrm>
          </p:grpSpPr>
          <p:sp>
            <p:nvSpPr>
              <p:cNvPr id="53" name="フリーフォーム 52"/>
              <p:cNvSpPr/>
              <p:nvPr/>
            </p:nvSpPr>
            <p:spPr bwMode="auto">
              <a:xfrm>
                <a:off x="2554863" y="3754416"/>
                <a:ext cx="728504" cy="723739"/>
              </a:xfrm>
              <a:custGeom>
                <a:avLst/>
                <a:gdLst>
                  <a:gd name="connsiteX0" fmla="*/ 109182 w 573206"/>
                  <a:gd name="connsiteY0" fmla="*/ 0 h 709683"/>
                  <a:gd name="connsiteX1" fmla="*/ 109182 w 573206"/>
                  <a:gd name="connsiteY1" fmla="*/ 0 h 709683"/>
                  <a:gd name="connsiteX2" fmla="*/ 382137 w 573206"/>
                  <a:gd name="connsiteY2" fmla="*/ 13648 h 709683"/>
                  <a:gd name="connsiteX3" fmla="*/ 464024 w 573206"/>
                  <a:gd name="connsiteY3" fmla="*/ 40943 h 709683"/>
                  <a:gd name="connsiteX4" fmla="*/ 573206 w 573206"/>
                  <a:gd name="connsiteY4" fmla="*/ 81886 h 709683"/>
                  <a:gd name="connsiteX5" fmla="*/ 559558 w 573206"/>
                  <a:gd name="connsiteY5" fmla="*/ 354842 h 709683"/>
                  <a:gd name="connsiteX6" fmla="*/ 532262 w 573206"/>
                  <a:gd name="connsiteY6" fmla="*/ 436728 h 709683"/>
                  <a:gd name="connsiteX7" fmla="*/ 504967 w 573206"/>
                  <a:gd name="connsiteY7" fmla="*/ 518615 h 709683"/>
                  <a:gd name="connsiteX8" fmla="*/ 477671 w 573206"/>
                  <a:gd name="connsiteY8" fmla="*/ 559558 h 709683"/>
                  <a:gd name="connsiteX9" fmla="*/ 382137 w 573206"/>
                  <a:gd name="connsiteY9" fmla="*/ 655092 h 709683"/>
                  <a:gd name="connsiteX10" fmla="*/ 341194 w 573206"/>
                  <a:gd name="connsiteY10" fmla="*/ 682388 h 709683"/>
                  <a:gd name="connsiteX11" fmla="*/ 259307 w 573206"/>
                  <a:gd name="connsiteY11" fmla="*/ 709683 h 709683"/>
                  <a:gd name="connsiteX12" fmla="*/ 163773 w 573206"/>
                  <a:gd name="connsiteY12" fmla="*/ 696036 h 709683"/>
                  <a:gd name="connsiteX13" fmla="*/ 150125 w 573206"/>
                  <a:gd name="connsiteY13" fmla="*/ 655092 h 709683"/>
                  <a:gd name="connsiteX14" fmla="*/ 81886 w 573206"/>
                  <a:gd name="connsiteY14" fmla="*/ 586853 h 709683"/>
                  <a:gd name="connsiteX15" fmla="*/ 54591 w 573206"/>
                  <a:gd name="connsiteY15" fmla="*/ 545910 h 709683"/>
                  <a:gd name="connsiteX16" fmla="*/ 0 w 573206"/>
                  <a:gd name="connsiteY16" fmla="*/ 491319 h 709683"/>
                  <a:gd name="connsiteX17" fmla="*/ 0 w 573206"/>
                  <a:gd name="connsiteY17" fmla="*/ 491319 h 7096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573206" h="709683">
                    <a:moveTo>
                      <a:pt x="109182" y="0"/>
                    </a:moveTo>
                    <a:lnTo>
                      <a:pt x="109182" y="0"/>
                    </a:lnTo>
                    <a:cubicBezTo>
                      <a:pt x="200167" y="4549"/>
                      <a:pt x="291639" y="3206"/>
                      <a:pt x="382137" y="13648"/>
                    </a:cubicBezTo>
                    <a:cubicBezTo>
                      <a:pt x="410719" y="16946"/>
                      <a:pt x="436728" y="31845"/>
                      <a:pt x="464024" y="40943"/>
                    </a:cubicBezTo>
                    <a:cubicBezTo>
                      <a:pt x="528198" y="62334"/>
                      <a:pt x="491628" y="49255"/>
                      <a:pt x="573206" y="81886"/>
                    </a:cubicBezTo>
                    <a:cubicBezTo>
                      <a:pt x="568657" y="172871"/>
                      <a:pt x="570000" y="264343"/>
                      <a:pt x="559558" y="354842"/>
                    </a:cubicBezTo>
                    <a:cubicBezTo>
                      <a:pt x="556260" y="383424"/>
                      <a:pt x="541360" y="409433"/>
                      <a:pt x="532262" y="436728"/>
                    </a:cubicBezTo>
                    <a:cubicBezTo>
                      <a:pt x="532261" y="436732"/>
                      <a:pt x="504969" y="518612"/>
                      <a:pt x="504967" y="518615"/>
                    </a:cubicBezTo>
                    <a:lnTo>
                      <a:pt x="477671" y="559558"/>
                    </a:lnTo>
                    <a:cubicBezTo>
                      <a:pt x="453650" y="631623"/>
                      <a:pt x="475994" y="592520"/>
                      <a:pt x="382137" y="655092"/>
                    </a:cubicBezTo>
                    <a:cubicBezTo>
                      <a:pt x="368489" y="664191"/>
                      <a:pt x="356755" y="677201"/>
                      <a:pt x="341194" y="682388"/>
                    </a:cubicBezTo>
                    <a:lnTo>
                      <a:pt x="259307" y="709683"/>
                    </a:lnTo>
                    <a:cubicBezTo>
                      <a:pt x="227462" y="705134"/>
                      <a:pt x="192545" y="710422"/>
                      <a:pt x="163773" y="696036"/>
                    </a:cubicBezTo>
                    <a:cubicBezTo>
                      <a:pt x="150906" y="689602"/>
                      <a:pt x="156559" y="667959"/>
                      <a:pt x="150125" y="655092"/>
                    </a:cubicBezTo>
                    <a:cubicBezTo>
                      <a:pt x="127379" y="609599"/>
                      <a:pt x="122830" y="614149"/>
                      <a:pt x="81886" y="586853"/>
                    </a:cubicBezTo>
                    <a:cubicBezTo>
                      <a:pt x="72788" y="573205"/>
                      <a:pt x="66189" y="557508"/>
                      <a:pt x="54591" y="545910"/>
                    </a:cubicBezTo>
                    <a:cubicBezTo>
                      <a:pt x="-11286" y="480033"/>
                      <a:pt x="31198" y="553714"/>
                      <a:pt x="0" y="491319"/>
                    </a:cubicBezTo>
                    <a:lnTo>
                      <a:pt x="0" y="491319"/>
                    </a:lnTo>
                  </a:path>
                </a:pathLst>
              </a:cu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sp>
            <p:nvSpPr>
              <p:cNvPr id="54" name="正方形/長方形 53"/>
              <p:cNvSpPr/>
              <p:nvPr/>
            </p:nvSpPr>
            <p:spPr bwMode="auto">
              <a:xfrm>
                <a:off x="3867440" y="5866909"/>
                <a:ext cx="88881" cy="8888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55" name="二等辺三角形 54"/>
              <p:cNvSpPr/>
              <p:nvPr/>
            </p:nvSpPr>
            <p:spPr bwMode="auto">
              <a:xfrm>
                <a:off x="3556358" y="6202815"/>
                <a:ext cx="88881" cy="88881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56" name="円/楕円 55"/>
              <p:cNvSpPr>
                <a:spLocks/>
              </p:cNvSpPr>
              <p:nvPr/>
            </p:nvSpPr>
            <p:spPr bwMode="auto">
              <a:xfrm>
                <a:off x="3921403" y="6184339"/>
                <a:ext cx="88881" cy="88880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sp>
            <p:nvSpPr>
              <p:cNvPr id="57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3992956" y="5454340"/>
                <a:ext cx="357812" cy="3941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58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4777451" y="4278072"/>
                <a:ext cx="696957" cy="4253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2752204" y="5937283"/>
                <a:ext cx="667178" cy="4253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b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0" name="直線コネクタ 59"/>
              <p:cNvCxnSpPr/>
              <p:nvPr/>
            </p:nvCxnSpPr>
            <p:spPr bwMode="auto">
              <a:xfrm flipH="1">
                <a:off x="4237524" y="4647562"/>
                <a:ext cx="668388" cy="9844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線コネクタ 60"/>
              <p:cNvCxnSpPr/>
              <p:nvPr/>
            </p:nvCxnSpPr>
            <p:spPr bwMode="auto">
              <a:xfrm flipV="1">
                <a:off x="3325898" y="5992323"/>
                <a:ext cx="907772" cy="15714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4097110" y="5786557"/>
                <a:ext cx="365076" cy="4000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63" name="角丸四角形 62"/>
              <p:cNvSpPr/>
              <p:nvPr/>
            </p:nvSpPr>
            <p:spPr>
              <a:xfrm>
                <a:off x="2572322" y="3875039"/>
                <a:ext cx="58724" cy="182521"/>
              </a:xfrm>
              <a:prstGeom prst="round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sp>
            <p:nvSpPr>
              <p:cNvPr id="64" name="テキスト ボックス 92"/>
              <p:cNvSpPr txBox="1">
                <a:spLocks noChangeArrowheads="1"/>
              </p:cNvSpPr>
              <p:nvPr/>
            </p:nvSpPr>
            <p:spPr bwMode="auto">
              <a:xfrm>
                <a:off x="2560370" y="6638787"/>
                <a:ext cx="2836371" cy="614546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 from Tr. sup, A</a:t>
                </a:r>
                <a:r>
                  <a:rPr lang="en-US" altLang="ja-JP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 from </a:t>
                </a:r>
                <a:r>
                  <a:rPr lang="en-US" altLang="ja-JP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Tr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ja-JP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f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</a:t>
                </a:r>
                <a:r>
                  <a:rPr lang="en-US" altLang="ja-JP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.6%</a:t>
                </a:r>
                <a:endPara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テキスト ボックス 94"/>
              <p:cNvSpPr txBox="1">
                <a:spLocks noChangeArrowheads="1"/>
              </p:cNvSpPr>
              <p:nvPr/>
            </p:nvSpPr>
            <p:spPr bwMode="auto">
              <a:xfrm>
                <a:off x="2889371" y="3847024"/>
                <a:ext cx="2613985" cy="363736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. </a:t>
                </a:r>
                <a:r>
                  <a:rPr lang="en-US" altLang="ja-JP" sz="1200" b="1" u="sng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+Tr</a:t>
                </a: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ja-JP" sz="1200" b="1" u="sng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f+A</a:t>
                </a: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ja-JP" sz="1200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c</a:t>
                </a: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ype</a:t>
                </a:r>
                <a:endParaRPr lang="ja-JP" altLang="en-US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コンテンツ プレースホルダー 7"/>
              <p:cNvSpPr txBox="1">
                <a:spLocks/>
              </p:cNvSpPr>
              <p:nvPr/>
            </p:nvSpPr>
            <p:spPr bwMode="auto">
              <a:xfrm>
                <a:off x="2473734" y="3723585"/>
                <a:ext cx="496781" cy="415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noAutofit/>
              </a:bodyPr>
              <a:lstStyle>
                <a:lvl1pPr marL="228600" indent="-228600" algn="l" rtl="0" fontAlgn="base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eaLnBrk="1" fontAlgn="auto" hangingPunct="1">
                  <a:spcAft>
                    <a:spcPts val="0"/>
                  </a:spcAft>
                  <a:buFont typeface="Arial" panose="020B0604020202020204" pitchFamily="34" charset="0"/>
                  <a:buNone/>
                  <a:defRPr/>
                </a:pPr>
                <a:r>
                  <a:rPr lang="en-US" altLang="ja-JP" sz="2600" dirty="0" smtClean="0"/>
                  <a:t>d</a:t>
                </a:r>
                <a:endParaRPr lang="ja-JP" altLang="en-US" sz="2600" dirty="0"/>
              </a:p>
            </p:txBody>
          </p:sp>
        </p:grpSp>
      </p:grpSp>
      <p:grpSp>
        <p:nvGrpSpPr>
          <p:cNvPr id="67" name="グループ化 1"/>
          <p:cNvGrpSpPr>
            <a:grpSpLocks noChangeAspect="1"/>
          </p:cNvGrpSpPr>
          <p:nvPr/>
        </p:nvGrpSpPr>
        <p:grpSpPr bwMode="auto">
          <a:xfrm>
            <a:off x="3748561" y="5493453"/>
            <a:ext cx="2279900" cy="2712722"/>
            <a:chOff x="8554797" y="3654282"/>
            <a:chExt cx="2893932" cy="3443326"/>
          </a:xfrm>
        </p:grpSpPr>
        <p:grpSp>
          <p:nvGrpSpPr>
            <p:cNvPr id="68" name="グループ化 13"/>
            <p:cNvGrpSpPr>
              <a:grpSpLocks/>
            </p:cNvGrpSpPr>
            <p:nvPr/>
          </p:nvGrpSpPr>
          <p:grpSpPr bwMode="auto">
            <a:xfrm>
              <a:off x="8554797" y="3654282"/>
              <a:ext cx="2888369" cy="3443326"/>
              <a:chOff x="8570725" y="3723886"/>
              <a:chExt cx="2888319" cy="3443652"/>
            </a:xfrm>
          </p:grpSpPr>
          <p:pic>
            <p:nvPicPr>
              <p:cNvPr id="70" name="図 1"/>
              <p:cNvPicPr>
                <a:picLocks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468" t="10975" r="-703"/>
              <a:stretch/>
            </p:blipFill>
            <p:spPr bwMode="auto">
              <a:xfrm>
                <a:off x="8717355" y="4188282"/>
                <a:ext cx="2741689" cy="23763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1" name="正方形/長方形 70"/>
              <p:cNvSpPr/>
              <p:nvPr/>
            </p:nvSpPr>
            <p:spPr bwMode="auto">
              <a:xfrm>
                <a:off x="10523817" y="4844350"/>
                <a:ext cx="88898" cy="9049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72" name="二等辺三角形 71"/>
              <p:cNvSpPr/>
              <p:nvPr/>
            </p:nvSpPr>
            <p:spPr bwMode="auto">
              <a:xfrm>
                <a:off x="9881633" y="5276059"/>
                <a:ext cx="90486" cy="88909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  <p:sp>
            <p:nvSpPr>
              <p:cNvPr id="73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10242087" y="5715424"/>
                <a:ext cx="365125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74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10080432" y="5353027"/>
                <a:ext cx="263951" cy="3469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75" name="テキスト ボックス 33"/>
              <p:cNvSpPr txBox="1">
                <a:spLocks noChangeArrowheads="1"/>
              </p:cNvSpPr>
              <p:nvPr/>
            </p:nvSpPr>
            <p:spPr bwMode="auto">
              <a:xfrm>
                <a:off x="10496307" y="5058438"/>
                <a:ext cx="365125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ja-JP" altLang="en-US" sz="20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76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9045352" y="5136680"/>
                <a:ext cx="711199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7" name="直線コネクタ 76"/>
              <p:cNvCxnSpPr/>
              <p:nvPr/>
            </p:nvCxnSpPr>
            <p:spPr bwMode="auto">
              <a:xfrm>
                <a:off x="9595034" y="5416327"/>
                <a:ext cx="613753" cy="1111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線コネクタ 77"/>
              <p:cNvCxnSpPr/>
              <p:nvPr/>
            </p:nvCxnSpPr>
            <p:spPr bwMode="auto">
              <a:xfrm flipH="1" flipV="1">
                <a:off x="10502475" y="5930528"/>
                <a:ext cx="367240" cy="13085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テキスト ボックス 38927"/>
              <p:cNvSpPr txBox="1">
                <a:spLocks noChangeArrowheads="1"/>
              </p:cNvSpPr>
              <p:nvPr/>
            </p:nvSpPr>
            <p:spPr bwMode="auto">
              <a:xfrm>
                <a:off x="9412053" y="4127331"/>
                <a:ext cx="711201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just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6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Times New Roman" panose="02020603050405020304" pitchFamily="18" charset="0"/>
                  </a:rPr>
                  <a:t>b </a:t>
                </a:r>
                <a:endParaRPr lang="ja-JP" altLang="ja-JP" sz="16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0" name="直線コネクタ 79"/>
              <p:cNvCxnSpPr/>
              <p:nvPr/>
            </p:nvCxnSpPr>
            <p:spPr bwMode="auto">
              <a:xfrm>
                <a:off x="9898695" y="4453456"/>
                <a:ext cx="738709" cy="79061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コンテンツ プレースホルダー 7"/>
              <p:cNvSpPr txBox="1">
                <a:spLocks/>
              </p:cNvSpPr>
              <p:nvPr/>
            </p:nvSpPr>
            <p:spPr bwMode="auto">
              <a:xfrm>
                <a:off x="8570725" y="3723886"/>
                <a:ext cx="496879" cy="4159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noAutofit/>
              </a:bodyPr>
              <a:lstStyle>
                <a:lvl1pPr marL="228600" indent="-228600" algn="l" rtl="0" fontAlgn="base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fontAlgn="base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eaLnBrk="1" fontAlgn="auto" hangingPunct="1">
                  <a:spcAft>
                    <a:spcPts val="0"/>
                  </a:spcAft>
                  <a:buFont typeface="Arial" panose="020B0604020202020204" pitchFamily="34" charset="0"/>
                  <a:buNone/>
                  <a:defRPr/>
                </a:pPr>
                <a:r>
                  <a:rPr lang="en-US" altLang="ja-JP" sz="2600" dirty="0" smtClean="0"/>
                  <a:t>f</a:t>
                </a:r>
                <a:endParaRPr lang="ja-JP" altLang="en-US" sz="2600" dirty="0"/>
              </a:p>
            </p:txBody>
          </p:sp>
          <p:sp>
            <p:nvSpPr>
              <p:cNvPr id="82" name="テキスト ボックス 94"/>
              <p:cNvSpPr txBox="1">
                <a:spLocks noChangeArrowheads="1"/>
              </p:cNvSpPr>
              <p:nvPr/>
            </p:nvSpPr>
            <p:spPr bwMode="auto">
              <a:xfrm>
                <a:off x="8691000" y="6581480"/>
                <a:ext cx="2741687" cy="58605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ja-JP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 from A</a:t>
                </a:r>
                <a:r>
                  <a:rPr lang="en-US" altLang="ja-JP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+5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</a:t>
                </a:r>
                <a:endPara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  <a:endPara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テキスト ボックス 92"/>
              <p:cNvSpPr txBox="1">
                <a:spLocks noChangeArrowheads="1"/>
              </p:cNvSpPr>
              <p:nvPr/>
            </p:nvSpPr>
            <p:spPr bwMode="auto">
              <a:xfrm>
                <a:off x="9394257" y="3894708"/>
                <a:ext cx="1919436" cy="351635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kumimoji="1"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umimoji="1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. </a:t>
                </a:r>
                <a:r>
                  <a:rPr lang="en-US" altLang="ja-JP" sz="1200" b="1" u="sng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+A</a:t>
                </a: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ja-JP" sz="1200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c</a:t>
                </a:r>
                <a:r>
                  <a:rPr lang="en-US" altLang="ja-JP" sz="12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ype</a:t>
                </a:r>
                <a:endParaRPr lang="ja-JP" altLang="en-US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9" name="テキスト ボックス 38927"/>
            <p:cNvSpPr txBox="1">
              <a:spLocks noChangeArrowheads="1"/>
            </p:cNvSpPr>
            <p:nvPr/>
          </p:nvSpPr>
          <p:spPr bwMode="auto">
            <a:xfrm>
              <a:off x="10737529" y="5805238"/>
              <a:ext cx="711200" cy="431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just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60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</a:t>
              </a:r>
              <a:r>
                <a:rPr lang="en-US" altLang="ja-JP" sz="16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4+5</a:t>
              </a:r>
              <a:r>
                <a:rPr lang="en-US" altLang="ja-JP" sz="160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 </a:t>
              </a:r>
              <a:endParaRPr lang="ja-JP" altLang="ja-JP" sz="16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4" name="グループ化 2"/>
          <p:cNvGrpSpPr>
            <a:grpSpLocks noChangeAspect="1"/>
          </p:cNvGrpSpPr>
          <p:nvPr/>
        </p:nvGrpSpPr>
        <p:grpSpPr bwMode="auto">
          <a:xfrm>
            <a:off x="1362930" y="46346"/>
            <a:ext cx="2221508" cy="2729008"/>
            <a:chOff x="2485567" y="202927"/>
            <a:chExt cx="2883264" cy="3541337"/>
          </a:xfrm>
        </p:grpSpPr>
        <p:pic>
          <p:nvPicPr>
            <p:cNvPr id="85" name="図 1"/>
            <p:cNvPicPr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257" r="4933" b="5092"/>
            <a:stretch/>
          </p:blipFill>
          <p:spPr bwMode="auto">
            <a:xfrm>
              <a:off x="2565399" y="698995"/>
              <a:ext cx="2803432" cy="24292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6" name="テキスト ボックス 87"/>
            <p:cNvSpPr txBox="1">
              <a:spLocks noChangeArrowheads="1"/>
            </p:cNvSpPr>
            <p:nvPr/>
          </p:nvSpPr>
          <p:spPr bwMode="auto">
            <a:xfrm>
              <a:off x="2545092" y="3145178"/>
              <a:ext cx="2803432" cy="59908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+A</a:t>
              </a:r>
              <a:r>
                <a:rPr lang="en-US" altLang="ja-JP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from Tr. sup</a:t>
              </a:r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</a:t>
              </a:r>
            </a:p>
            <a:p>
              <a:pPr algn="ctr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68.5%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正方形/長方形 86"/>
            <p:cNvSpPr/>
            <p:nvPr/>
          </p:nvSpPr>
          <p:spPr>
            <a:xfrm>
              <a:off x="4203633" y="2587724"/>
              <a:ext cx="90493" cy="888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ja-JP" altLang="en-US"/>
            </a:p>
          </p:txBody>
        </p:sp>
        <p:sp>
          <p:nvSpPr>
            <p:cNvPr id="88" name="二等辺三角形 87"/>
            <p:cNvSpPr/>
            <p:nvPr/>
          </p:nvSpPr>
          <p:spPr>
            <a:xfrm>
              <a:off x="3641528" y="2805526"/>
              <a:ext cx="99541" cy="90477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ja-JP" altLang="en-US"/>
            </a:p>
          </p:txBody>
        </p:sp>
        <p:sp>
          <p:nvSpPr>
            <p:cNvPr id="89" name="テキスト ボックス 33"/>
            <p:cNvSpPr txBox="1">
              <a:spLocks noChangeArrowheads="1"/>
            </p:cNvSpPr>
            <p:nvPr/>
          </p:nvSpPr>
          <p:spPr bwMode="auto">
            <a:xfrm>
              <a:off x="3608388" y="1882775"/>
              <a:ext cx="365125" cy="401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ja-JP" altLang="en-US" sz="200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90" name="テキスト ボックス 33"/>
            <p:cNvSpPr txBox="1">
              <a:spLocks noChangeArrowheads="1"/>
            </p:cNvSpPr>
            <p:nvPr/>
          </p:nvSpPr>
          <p:spPr bwMode="auto">
            <a:xfrm>
              <a:off x="4067513" y="1998095"/>
              <a:ext cx="365125" cy="4000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ja-JP" altLang="en-US" sz="20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91" name="テキスト ボックス 38927"/>
            <p:cNvSpPr txBox="1">
              <a:spLocks noChangeArrowheads="1"/>
            </p:cNvSpPr>
            <p:nvPr/>
          </p:nvSpPr>
          <p:spPr bwMode="auto">
            <a:xfrm>
              <a:off x="2610855" y="2590854"/>
              <a:ext cx="711201" cy="431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just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60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</a:t>
              </a:r>
              <a:r>
                <a:rPr lang="en-US" altLang="ja-JP" sz="16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3</a:t>
              </a:r>
              <a:r>
                <a:rPr lang="en-US" altLang="ja-JP" sz="160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 </a:t>
              </a:r>
              <a:endParaRPr lang="ja-JP" altLang="ja-JP" sz="16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92" name="テキスト ボックス 38927"/>
            <p:cNvSpPr txBox="1">
              <a:spLocks noChangeArrowheads="1"/>
            </p:cNvSpPr>
            <p:nvPr/>
          </p:nvSpPr>
          <p:spPr bwMode="auto">
            <a:xfrm>
              <a:off x="3783443" y="626726"/>
              <a:ext cx="711201" cy="4317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just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60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</a:t>
              </a:r>
              <a:r>
                <a:rPr lang="en-US" altLang="ja-JP" sz="16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3</a:t>
              </a:r>
              <a:r>
                <a:rPr lang="en-US" altLang="ja-JP" sz="1600" dirty="0">
                  <a:solidFill>
                    <a:srgbClr val="000000"/>
                  </a:solidFill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b </a:t>
              </a:r>
              <a:endParaRPr lang="ja-JP" altLang="ja-JP" sz="16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93" name="直線コネクタ 92"/>
            <p:cNvCxnSpPr/>
            <p:nvPr/>
          </p:nvCxnSpPr>
          <p:spPr>
            <a:xfrm>
              <a:off x="4076242" y="996724"/>
              <a:ext cx="184326" cy="115505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/>
            <p:cNvCxnSpPr/>
            <p:nvPr/>
          </p:nvCxnSpPr>
          <p:spPr>
            <a:xfrm flipV="1">
              <a:off x="3074373" y="2090404"/>
              <a:ext cx="669960" cy="646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テキスト ボックス 90"/>
            <p:cNvSpPr txBox="1">
              <a:spLocks noChangeArrowheads="1"/>
            </p:cNvSpPr>
            <p:nvPr/>
          </p:nvSpPr>
          <p:spPr bwMode="auto">
            <a:xfrm>
              <a:off x="3077035" y="388493"/>
              <a:ext cx="1893878" cy="359452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. </a:t>
              </a:r>
              <a:r>
                <a:rPr lang="en-US" altLang="ja-JP" sz="1200" b="1" u="sng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+A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ja-JP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sc</a:t>
              </a:r>
              <a:r>
                <a:rPr lang="en-US" altLang="ja-JP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ype</a:t>
              </a:r>
              <a:endParaRPr lang="ja-JP" alt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コンテンツ プレースホルダー 7"/>
            <p:cNvSpPr txBox="1">
              <a:spLocks/>
            </p:cNvSpPr>
            <p:nvPr/>
          </p:nvSpPr>
          <p:spPr bwMode="auto">
            <a:xfrm>
              <a:off x="2485567" y="202927"/>
              <a:ext cx="496914" cy="4158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noAutofit/>
            </a:bodyPr>
            <a:lstStyle>
              <a:lvl1pPr marL="228600" indent="-228600" algn="l" rtl="0" fontAlgn="base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fontAlgn="base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ctr" eaLnBrk="1" fontAlgn="auto" hangingPunct="1">
                <a:spcAft>
                  <a:spcPts val="0"/>
                </a:spcAft>
                <a:buFont typeface="Arial" panose="020B0604020202020204" pitchFamily="34" charset="0"/>
                <a:buNone/>
                <a:defRPr/>
              </a:pPr>
              <a:r>
                <a:rPr lang="en-US" altLang="ja-JP" sz="2600" dirty="0"/>
                <a:t>a</a:t>
              </a:r>
              <a:endParaRPr lang="ja-JP" altLang="en-US" sz="2600" dirty="0"/>
            </a:p>
          </p:txBody>
        </p:sp>
      </p:grpSp>
      <p:sp>
        <p:nvSpPr>
          <p:cNvPr id="97" name="タイトル 1"/>
          <p:cNvSpPr>
            <a:spLocks noGrp="1"/>
          </p:cNvSpPr>
          <p:nvPr>
            <p:ph type="title"/>
          </p:nvPr>
        </p:nvSpPr>
        <p:spPr>
          <a:xfrm>
            <a:off x="-617" y="52352"/>
            <a:ext cx="1273493" cy="481993"/>
          </a:xfrm>
        </p:spPr>
        <p:txBody>
          <a:bodyPr/>
          <a:lstStyle/>
          <a:p>
            <a:pPr eaLnBrk="1" hangingPunct="1"/>
            <a:r>
              <a:rPr lang="en-US" altLang="ja-JP" sz="20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-Figure 3</a:t>
            </a:r>
            <a:endParaRPr lang="ja-JP" altLang="en-US" sz="2000" u="sng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02311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2"/>
          <p:cNvGrpSpPr>
            <a:grpSpLocks noChangeAspect="1"/>
          </p:cNvGrpSpPr>
          <p:nvPr/>
        </p:nvGrpSpPr>
        <p:grpSpPr bwMode="auto">
          <a:xfrm>
            <a:off x="1521101" y="1578597"/>
            <a:ext cx="2879725" cy="3290887"/>
            <a:chOff x="4152900" y="1631950"/>
            <a:chExt cx="3779838" cy="4319588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52900" y="1631950"/>
              <a:ext cx="3779838" cy="4319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テキスト ボックス 3"/>
            <p:cNvSpPr txBox="1">
              <a:spLocks noChangeArrowheads="1"/>
            </p:cNvSpPr>
            <p:nvPr/>
          </p:nvSpPr>
          <p:spPr bwMode="auto">
            <a:xfrm>
              <a:off x="4593846" y="4616450"/>
              <a:ext cx="906842" cy="4847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800" b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VI</a:t>
              </a:r>
              <a:endParaRPr lang="ja-JP" altLang="en-US" sz="1800" b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右矢印 6"/>
            <p:cNvSpPr/>
            <p:nvPr/>
          </p:nvSpPr>
          <p:spPr>
            <a:xfrm rot="2290438">
              <a:off x="5111404" y="3717771"/>
              <a:ext cx="275049" cy="216709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ln>
                  <a:solidFill>
                    <a:sysClr val="windowText" lastClr="000000"/>
                  </a:solidFill>
                </a:ln>
              </a:endParaRPr>
            </a:p>
          </p:txBody>
        </p:sp>
        <p:sp>
          <p:nvSpPr>
            <p:cNvPr id="8" name="右矢印 7"/>
            <p:cNvSpPr/>
            <p:nvPr/>
          </p:nvSpPr>
          <p:spPr>
            <a:xfrm rot="2290438">
              <a:off x="5396872" y="3305191"/>
              <a:ext cx="275049" cy="216709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ln>
                  <a:solidFill>
                    <a:sysClr val="windowText" lastClr="000000"/>
                  </a:solidFill>
                </a:ln>
              </a:endParaRPr>
            </a:p>
          </p:txBody>
        </p:sp>
        <p:sp>
          <p:nvSpPr>
            <p:cNvPr id="9" name="右矢印 8"/>
            <p:cNvSpPr/>
            <p:nvPr/>
          </p:nvSpPr>
          <p:spPr>
            <a:xfrm rot="2290438">
              <a:off x="5738599" y="2946788"/>
              <a:ext cx="275049" cy="214626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ln>
                  <a:solidFill>
                    <a:sysClr val="windowText" lastClr="000000"/>
                  </a:solidFill>
                </a:ln>
              </a:endParaRPr>
            </a:p>
          </p:txBody>
        </p:sp>
      </p:grpSp>
      <p:sp>
        <p:nvSpPr>
          <p:cNvPr id="10" name="タイトル 1"/>
          <p:cNvSpPr>
            <a:spLocks noGrp="1"/>
          </p:cNvSpPr>
          <p:nvPr>
            <p:ph type="title"/>
          </p:nvPr>
        </p:nvSpPr>
        <p:spPr>
          <a:xfrm>
            <a:off x="391147" y="262492"/>
            <a:ext cx="1257300" cy="812800"/>
          </a:xfrm>
        </p:spPr>
        <p:txBody>
          <a:bodyPr/>
          <a:lstStyle/>
          <a:p>
            <a:pPr eaLnBrk="1" hangingPunct="1"/>
            <a:r>
              <a:rPr lang="en-US" altLang="ja-JP" sz="2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ja-JP" sz="20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Figure 4</a:t>
            </a:r>
            <a:endParaRPr lang="ja-JP" altLang="en-US" sz="2000" u="sng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1915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7</TotalTime>
  <Words>322</Words>
  <Application>Microsoft Office PowerPoint</Application>
  <PresentationFormat>ユーザー設定</PresentationFormat>
  <Paragraphs>121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e-Figure 1</vt:lpstr>
      <vt:lpstr>e-Figure 2</vt:lpstr>
      <vt:lpstr>e-Figure 3</vt:lpstr>
      <vt:lpstr>e-Figure 4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teru</dc:creator>
  <cp:lastModifiedBy>Toshiteru</cp:lastModifiedBy>
  <cp:revision>27</cp:revision>
  <dcterms:created xsi:type="dcterms:W3CDTF">2014-12-17T06:41:11Z</dcterms:created>
  <dcterms:modified xsi:type="dcterms:W3CDTF">2015-02-07T09:31:13Z</dcterms:modified>
</cp:coreProperties>
</file>